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9.wmf" ContentType="image/x-wmf"/>
  <Override PartName="/ppt/media/image13.wmf" ContentType="image/x-wmf"/>
  <Override PartName="/ppt/media/image8.wmf" ContentType="image/x-wmf"/>
  <Override PartName="/ppt/media/image12.wmf" ContentType="image/x-wmf"/>
  <Override PartName="/ppt/media/image7.wmf" ContentType="image/x-wmf"/>
  <Override PartName="/ppt/media/image11.wmf" ContentType="image/x-wmf"/>
  <Override PartName="/ppt/media/image6.wmf" ContentType="image/x-wmf"/>
  <Override PartName="/ppt/media/image19.wmf" ContentType="image/x-wmf"/>
  <Override PartName="/ppt/media/image1.wmf" ContentType="image/x-wmf"/>
  <Override PartName="/ppt/media/image3.wmf" ContentType="image/x-wmf"/>
  <Override PartName="/ppt/media/image20.wmf" ContentType="image/x-wmf"/>
  <Override PartName="/ppt/media/image18.wmf" ContentType="image/x-wmf"/>
  <Override PartName="/ppt/media/image17.wmf" ContentType="image/x-wmf"/>
  <Override PartName="/ppt/media/image16.wmf" ContentType="image/x-wmf"/>
  <Override PartName="/ppt/media/image15.wmf" ContentType="image/x-wmf"/>
  <Override PartName="/ppt/media/image14.wmf" ContentType="image/x-wmf"/>
  <Override PartName="/ppt/media/image2.wmf" ContentType="image/x-wmf"/>
  <Override PartName="/ppt/media/image4.wmf" ContentType="image/x-wmf"/>
  <Override PartName="/ppt/media/image5.wmf" ContentType="image/x-wmf"/>
  <Override PartName="/ppt/media/image10.wmf" ContentType="image/x-wmf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F5DA9CE-90CA-4AF6-B795-CF91D80A87E7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endParaRPr b="0" lang="en-US" sz="4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85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825"/>
              </a:spcBef>
              <a:buNone/>
              <a:tabLst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endParaRPr b="0" lang="en-US" sz="3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880"/>
            <a:ext cx="6172200" cy="28785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825"/>
              </a:spcBef>
              <a:buNone/>
              <a:tabLst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endParaRPr b="0" lang="en-US" sz="3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95CB451-DF7E-41C7-9F56-CF1799A0B76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endParaRPr b="0" lang="en-US" sz="4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85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825"/>
              </a:spcBef>
              <a:buNone/>
              <a:tabLst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endParaRPr b="0" lang="en-US" sz="3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85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825"/>
              </a:spcBef>
              <a:buNone/>
              <a:tabLst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endParaRPr b="0" lang="en-US" sz="3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880"/>
            <a:ext cx="3011760" cy="28785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825"/>
              </a:spcBef>
              <a:buNone/>
              <a:tabLst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endParaRPr b="0" lang="en-US" sz="3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880"/>
            <a:ext cx="3011760" cy="28785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825"/>
              </a:spcBef>
              <a:buNone/>
              <a:tabLst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endParaRPr b="0" lang="en-US" sz="3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0269F80-BA87-4529-9A49-F8E86470E753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endParaRPr b="0" lang="en-US" sz="4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85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825"/>
              </a:spcBef>
              <a:buNone/>
              <a:tabLst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endParaRPr b="0" lang="en-US" sz="3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85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825"/>
              </a:spcBef>
              <a:buNone/>
              <a:tabLst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endParaRPr b="0" lang="en-US" sz="3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85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825"/>
              </a:spcBef>
              <a:buNone/>
              <a:tabLst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endParaRPr b="0" lang="en-US" sz="3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880"/>
            <a:ext cx="1987200" cy="28785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825"/>
              </a:spcBef>
              <a:buNone/>
              <a:tabLst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endParaRPr b="0" lang="en-US" sz="3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880"/>
            <a:ext cx="1987200" cy="28785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825"/>
              </a:spcBef>
              <a:buNone/>
              <a:tabLst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endParaRPr b="0" lang="en-US" sz="3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880"/>
            <a:ext cx="1987200" cy="28785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825"/>
              </a:spcBef>
              <a:buNone/>
              <a:tabLst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endParaRPr b="0" lang="en-US" sz="3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BA48762-33E0-4A59-B0DD-2A01FA29E62F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endParaRPr b="0" lang="en-US" sz="4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5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825"/>
              </a:spcBef>
              <a:buNone/>
              <a:tabLst>
                <a:tab algn="l" pos="0"/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endParaRPr b="0" lang="en-US" sz="3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C83B102-A45B-4951-8F11-E0417A50602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endParaRPr b="0" lang="en-US" sz="4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825"/>
              </a:spcBef>
              <a:buNone/>
              <a:tabLst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endParaRPr b="0" lang="en-US" sz="3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C2F325A-DC79-4A16-8EE1-CCE16660AC9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endParaRPr b="0" lang="en-US" sz="4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825"/>
              </a:spcBef>
              <a:buNone/>
              <a:tabLst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endParaRPr b="0" lang="en-US" sz="3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825"/>
              </a:spcBef>
              <a:buNone/>
              <a:tabLst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endParaRPr b="0" lang="en-US" sz="3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62AA018-2EB6-4DFB-8E50-AF06BF2FD49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endParaRPr b="0" lang="en-US" sz="4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25D5FB2-53EF-4CDE-83A5-150813FD78F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825"/>
              </a:spcBef>
              <a:tabLst>
                <a:tab algn="l" pos="0"/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endParaRPr b="0" lang="en-US" sz="3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E20480E-142E-429A-821B-B6F1612F109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endParaRPr b="0" lang="en-US" sz="4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85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825"/>
              </a:spcBef>
              <a:buNone/>
              <a:tabLst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endParaRPr b="0" lang="en-US" sz="3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825"/>
              </a:spcBef>
              <a:buNone/>
              <a:tabLst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endParaRPr b="0" lang="en-US" sz="3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880"/>
            <a:ext cx="3011760" cy="28785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825"/>
              </a:spcBef>
              <a:buNone/>
              <a:tabLst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endParaRPr b="0" lang="en-US" sz="3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D637DA2-8E04-4928-96F5-71D0F413A45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endParaRPr b="0" lang="en-US" sz="4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825"/>
              </a:spcBef>
              <a:buNone/>
              <a:tabLst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endParaRPr b="0" lang="en-US" sz="3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85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825"/>
              </a:spcBef>
              <a:buNone/>
              <a:tabLst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endParaRPr b="0" lang="en-US" sz="3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880"/>
            <a:ext cx="3011760" cy="28785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825"/>
              </a:spcBef>
              <a:buNone/>
              <a:tabLst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endParaRPr b="0" lang="en-US" sz="3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33A264A-EB24-4762-9148-0EF27E613F1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endParaRPr b="0" lang="en-US" sz="4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85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825"/>
              </a:spcBef>
              <a:buNone/>
              <a:tabLst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endParaRPr b="0" lang="en-US" sz="3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85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825"/>
              </a:spcBef>
              <a:buNone/>
              <a:tabLst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endParaRPr b="0" lang="en-US" sz="3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880"/>
            <a:ext cx="6172200" cy="28785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825"/>
              </a:spcBef>
              <a:buNone/>
              <a:tabLst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endParaRPr b="0" lang="en-US" sz="3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FC96AFE-3EE2-4954-99A9-355A9091D7F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r>
              <a:rPr b="0" lang="en-US" sz="43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marL="341280" indent="-341280">
              <a:spcBef>
                <a:spcPts val="825"/>
              </a:spcBef>
              <a:buClr>
                <a:srgbClr val="000000"/>
              </a:buClr>
              <a:buFont typeface="Arial"/>
              <a:buChar char="•"/>
              <a:tabLst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r>
              <a:rPr b="0" lang="en-US" sz="33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300" spc="-1" strike="noStrike">
              <a:solidFill>
                <a:srgbClr val="000000"/>
              </a:solidFill>
              <a:latin typeface="Calibri"/>
            </a:endParaRPr>
          </a:p>
          <a:p>
            <a:pPr lvl="1" marL="741240" indent="-284040">
              <a:spcBef>
                <a:spcPts val="825"/>
              </a:spcBef>
              <a:buClr>
                <a:srgbClr val="000000"/>
              </a:buClr>
              <a:buFont typeface="Arial"/>
              <a:buChar char="–"/>
              <a:tabLst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r>
              <a:rPr b="0" lang="en-US" sz="33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300" spc="-1" strike="noStrike">
              <a:solidFill>
                <a:srgbClr val="000000"/>
              </a:solidFill>
              <a:latin typeface="Calibri"/>
            </a:endParaRPr>
          </a:p>
          <a:p>
            <a:pPr lvl="2" marL="1139760" indent="-226800">
              <a:spcBef>
                <a:spcPts val="825"/>
              </a:spcBef>
              <a:buClr>
                <a:srgbClr val="000000"/>
              </a:buClr>
              <a:buFont typeface="Arial"/>
              <a:buChar char="•"/>
              <a:tabLst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r>
              <a:rPr b="0" lang="en-US" sz="33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300" spc="-1" strike="noStrike">
              <a:solidFill>
                <a:srgbClr val="000000"/>
              </a:solidFill>
              <a:latin typeface="Calibri"/>
            </a:endParaRPr>
          </a:p>
          <a:p>
            <a:pPr lvl="3" marL="1598760" indent="-227160">
              <a:spcBef>
                <a:spcPts val="825"/>
              </a:spcBef>
              <a:buClr>
                <a:srgbClr val="000000"/>
              </a:buClr>
              <a:buFont typeface="Arial"/>
              <a:buChar char="–"/>
              <a:tabLst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r>
              <a:rPr b="0" lang="en-US" sz="33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300" spc="-1" strike="noStrike">
              <a:solidFill>
                <a:srgbClr val="000000"/>
              </a:solidFill>
              <a:latin typeface="Calibri"/>
            </a:endParaRPr>
          </a:p>
          <a:p>
            <a:pPr lvl="4" marL="2055960" indent="-227160">
              <a:spcBef>
                <a:spcPts val="825"/>
              </a:spcBef>
              <a:buClr>
                <a:srgbClr val="000000"/>
              </a:buClr>
              <a:buFont typeface="Arial"/>
              <a:buChar char="»"/>
              <a:tabLst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r>
              <a:rPr b="0" lang="en-US" sz="33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300" spc="-1" strike="noStrike">
              <a:solidFill>
                <a:srgbClr val="000000"/>
              </a:solidFill>
              <a:latin typeface="Calibri"/>
            </a:endParaRPr>
          </a:p>
          <a:p>
            <a:pPr lvl="5" marL="2055960" indent="-227160">
              <a:spcBef>
                <a:spcPts val="825"/>
              </a:spcBef>
              <a:buClr>
                <a:srgbClr val="000000"/>
              </a:buClr>
              <a:buFont typeface="Arial"/>
              <a:buChar char="»"/>
              <a:tabLst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r>
              <a:rPr b="0" lang="en-US" sz="33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300" spc="-1" strike="noStrike">
              <a:solidFill>
                <a:srgbClr val="000000"/>
              </a:solidFill>
              <a:latin typeface="Calibri"/>
            </a:endParaRPr>
          </a:p>
          <a:p>
            <a:pPr lvl="6" marL="2055960" indent="-227160">
              <a:spcBef>
                <a:spcPts val="825"/>
              </a:spcBef>
              <a:buClr>
                <a:srgbClr val="000000"/>
              </a:buClr>
              <a:buFont typeface="Arial"/>
              <a:buChar char="»"/>
              <a:tabLst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r>
              <a:rPr b="0" lang="en-US" sz="33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708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lstStyle>
            <a:lvl1pPr indent="0">
              <a:buNone/>
              <a:tabLst>
                <a:tab algn="l" pos="0"/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1440" y="8475480"/>
            <a:ext cx="2175120" cy="48708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buNone/>
              <a:tabLst>
                <a:tab algn="l" pos="0"/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708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lstStyle>
            <a:lvl1pPr indent="0" algn="r">
              <a:buNone/>
              <a:tabLst>
                <a:tab algn="l" pos="0"/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fld id="{DD2C8699-860B-4348-A8BC-E98FD5A5C915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image" Target="../media/image2.wmf"/><Relationship Id="rId3" Type="http://schemas.openxmlformats.org/officeDocument/2006/relationships/image" Target="../media/image3.wmf"/><Relationship Id="rId4" Type="http://schemas.openxmlformats.org/officeDocument/2006/relationships/image" Target="../media/image4.wmf"/><Relationship Id="rId5" Type="http://schemas.openxmlformats.org/officeDocument/2006/relationships/image" Target="../media/image5.wmf"/><Relationship Id="rId6" Type="http://schemas.openxmlformats.org/officeDocument/2006/relationships/image" Target="../media/image6.wmf"/><Relationship Id="rId7" Type="http://schemas.openxmlformats.org/officeDocument/2006/relationships/image" Target="../media/image7.wmf"/><Relationship Id="rId8" Type="http://schemas.openxmlformats.org/officeDocument/2006/relationships/image" Target="../media/image8.wmf"/><Relationship Id="rId9" Type="http://schemas.openxmlformats.org/officeDocument/2006/relationships/image" Target="../media/image9.wmf"/><Relationship Id="rId10" Type="http://schemas.openxmlformats.org/officeDocument/2006/relationships/image" Target="../media/image10.wmf"/><Relationship Id="rId11" Type="http://schemas.openxmlformats.org/officeDocument/2006/relationships/image" Target="../media/image11.wmf"/><Relationship Id="rId12" Type="http://schemas.openxmlformats.org/officeDocument/2006/relationships/image" Target="../media/image12.wmf"/><Relationship Id="rId13" Type="http://schemas.openxmlformats.org/officeDocument/2006/relationships/image" Target="../media/image13.wmf"/><Relationship Id="rId14" Type="http://schemas.openxmlformats.org/officeDocument/2006/relationships/image" Target="../media/image14.wmf"/><Relationship Id="rId15" Type="http://schemas.openxmlformats.org/officeDocument/2006/relationships/image" Target="../media/image15.wmf"/><Relationship Id="rId16" Type="http://schemas.openxmlformats.org/officeDocument/2006/relationships/image" Target="../media/image16.wmf"/><Relationship Id="rId17" Type="http://schemas.openxmlformats.org/officeDocument/2006/relationships/image" Target="../media/image17.wmf"/><Relationship Id="rId18" Type="http://schemas.openxmlformats.org/officeDocument/2006/relationships/image" Target="../media/image18.wmf"/><Relationship Id="rId19" Type="http://schemas.openxmlformats.org/officeDocument/2006/relationships/image" Target="../media/image19.wmf"/><Relationship Id="rId20" Type="http://schemas.openxmlformats.org/officeDocument/2006/relationships/image" Target="../media/image20.wmf"/><Relationship Id="rId21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image" Target="../media/image2.wmf"/><Relationship Id="rId3" Type="http://schemas.openxmlformats.org/officeDocument/2006/relationships/image" Target="../media/image3.wmf"/><Relationship Id="rId4" Type="http://schemas.openxmlformats.org/officeDocument/2006/relationships/image" Target="../media/image4.wmf"/><Relationship Id="rId5" Type="http://schemas.openxmlformats.org/officeDocument/2006/relationships/image" Target="../media/image5.wmf"/><Relationship Id="rId6" Type="http://schemas.openxmlformats.org/officeDocument/2006/relationships/image" Target="../media/image6.wmf"/><Relationship Id="rId7" Type="http://schemas.openxmlformats.org/officeDocument/2006/relationships/image" Target="../media/image7.wmf"/><Relationship Id="rId8" Type="http://schemas.openxmlformats.org/officeDocument/2006/relationships/image" Target="../media/image8.wmf"/><Relationship Id="rId9" Type="http://schemas.openxmlformats.org/officeDocument/2006/relationships/image" Target="../media/image9.wmf"/><Relationship Id="rId10" Type="http://schemas.openxmlformats.org/officeDocument/2006/relationships/image" Target="../media/image10.wmf"/><Relationship Id="rId11" Type="http://schemas.openxmlformats.org/officeDocument/2006/relationships/image" Target="../media/image11.wmf"/><Relationship Id="rId12" Type="http://schemas.openxmlformats.org/officeDocument/2006/relationships/image" Target="../media/image12.wmf"/><Relationship Id="rId13" Type="http://schemas.openxmlformats.org/officeDocument/2006/relationships/image" Target="../media/image13.wmf"/><Relationship Id="rId14" Type="http://schemas.openxmlformats.org/officeDocument/2006/relationships/image" Target="../media/image14.wmf"/><Relationship Id="rId15" Type="http://schemas.openxmlformats.org/officeDocument/2006/relationships/image" Target="../media/image15.wmf"/><Relationship Id="rId16" Type="http://schemas.openxmlformats.org/officeDocument/2006/relationships/image" Target="../media/image16.wmf"/><Relationship Id="rId17" Type="http://schemas.openxmlformats.org/officeDocument/2006/relationships/image" Target="../media/image17.wmf"/><Relationship Id="rId18" Type="http://schemas.openxmlformats.org/officeDocument/2006/relationships/image" Target="../media/image18.wmf"/><Relationship Id="rId19" Type="http://schemas.openxmlformats.org/officeDocument/2006/relationships/image" Target="../media/image19.wmf"/><Relationship Id="rId20" Type="http://schemas.openxmlformats.org/officeDocument/2006/relationships/image" Target="../media/image20.wmf"/><Relationship Id="rId2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Group 4"/>
          <p:cNvGrpSpPr/>
          <p:nvPr/>
        </p:nvGrpSpPr>
        <p:grpSpPr>
          <a:xfrm>
            <a:off x="161280" y="127080"/>
            <a:ext cx="6525000" cy="8961480"/>
            <a:chOff x="161280" y="127080"/>
            <a:chExt cx="6525000" cy="8961480"/>
          </a:xfrm>
        </p:grpSpPr>
        <p:sp>
          <p:nvSpPr>
            <p:cNvPr id="42" name="Rectangle 100"/>
            <p:cNvSpPr/>
            <p:nvPr/>
          </p:nvSpPr>
          <p:spPr>
            <a:xfrm>
              <a:off x="255960" y="8706240"/>
              <a:ext cx="16754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5760"/>
                  <a:tab algn="l" pos="911160"/>
                  <a:tab algn="l" pos="1366920"/>
                  <a:tab algn="l" pos="1822320"/>
                  <a:tab algn="l" pos="2278080"/>
                  <a:tab algn="l" pos="2733840"/>
                  <a:tab algn="l" pos="3189240"/>
                  <a:tab algn="l" pos="3645000"/>
                  <a:tab algn="l" pos="4100400"/>
                  <a:tab algn="l" pos="4556160"/>
                  <a:tab algn="l" pos="5011560"/>
                  <a:tab algn="l" pos="5467320"/>
                  <a:tab algn="l" pos="5923080"/>
                  <a:tab algn="l" pos="6378480"/>
                  <a:tab algn="l" pos="6834240"/>
                  <a:tab algn="l" pos="7289640"/>
                  <a:tab algn="l" pos="7745400"/>
                  <a:tab algn="l" pos="8201160"/>
                  <a:tab algn="l" pos="8656560"/>
                  <a:tab algn="l" pos="911232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Expression/Phosphorylation Level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grpSp>
          <p:nvGrpSpPr>
            <p:cNvPr id="43" name="Group 1"/>
            <p:cNvGrpSpPr/>
            <p:nvPr/>
          </p:nvGrpSpPr>
          <p:grpSpPr>
            <a:xfrm>
              <a:off x="250200" y="8872920"/>
              <a:ext cx="6348960" cy="215640"/>
              <a:chOff x="250200" y="8872920"/>
              <a:chExt cx="6348960" cy="215640"/>
            </a:xfrm>
          </p:grpSpPr>
          <p:grpSp>
            <p:nvGrpSpPr>
              <p:cNvPr id="44" name="Group 102"/>
              <p:cNvGrpSpPr/>
              <p:nvPr/>
            </p:nvGrpSpPr>
            <p:grpSpPr>
              <a:xfrm>
                <a:off x="2437560" y="8872920"/>
                <a:ext cx="753480" cy="215640"/>
                <a:chOff x="2437560" y="8872920"/>
                <a:chExt cx="753480" cy="215640"/>
              </a:xfrm>
            </p:grpSpPr>
            <p:sp>
              <p:nvSpPr>
                <p:cNvPr id="45" name="Rectangle 103"/>
                <p:cNvSpPr/>
                <p:nvPr/>
              </p:nvSpPr>
              <p:spPr>
                <a:xfrm>
                  <a:off x="2580480" y="8872920"/>
                  <a:ext cx="61056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5760"/>
                      <a:tab algn="l" pos="911160"/>
                      <a:tab algn="l" pos="1366920"/>
                      <a:tab algn="l" pos="1822320"/>
                      <a:tab algn="l" pos="2278080"/>
                      <a:tab algn="l" pos="2733840"/>
                      <a:tab algn="l" pos="3189240"/>
                      <a:tab algn="l" pos="3645000"/>
                      <a:tab algn="l" pos="4100400"/>
                      <a:tab algn="l" pos="4556160"/>
                      <a:tab algn="l" pos="5011560"/>
                      <a:tab algn="l" pos="5467320"/>
                      <a:tab algn="l" pos="5923080"/>
                      <a:tab algn="l" pos="6378480"/>
                      <a:tab algn="l" pos="6834240"/>
                      <a:tab algn="l" pos="7289640"/>
                      <a:tab algn="l" pos="7745400"/>
                      <a:tab algn="l" pos="8201160"/>
                      <a:tab algn="l" pos="8656560"/>
                      <a:tab algn="l" pos="9112320"/>
                    </a:tabLst>
                  </a:pPr>
                  <a:r>
                    <a:rPr b="0" lang="en-US" sz="8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0.91-1.10</a:t>
                  </a:r>
                  <a:endParaRPr b="0" lang="en-US" sz="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46" name="Rounded Rectangle 148"/>
                <p:cNvSpPr/>
                <p:nvPr/>
              </p:nvSpPr>
              <p:spPr>
                <a:xfrm>
                  <a:off x="2437560" y="8928360"/>
                  <a:ext cx="182520" cy="109080"/>
                </a:xfrm>
                <a:prstGeom prst="roundRect">
                  <a:avLst>
                    <a:gd name="adj" fmla="val 16667"/>
                  </a:avLst>
                </a:prstGeom>
                <a:solidFill>
                  <a:srgbClr val="ffff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54720" rIns="54720" tIns="45000" bIns="45000" anchor="ctr">
                  <a:noAutofit/>
                </a:bodyPr>
                <a:p>
                  <a:pPr algn="ctr">
                    <a:lnSpc>
                      <a:spcPct val="9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  <p:grpSp>
            <p:nvGrpSpPr>
              <p:cNvPr id="47" name="Group 108"/>
              <p:cNvGrpSpPr/>
              <p:nvPr/>
            </p:nvGrpSpPr>
            <p:grpSpPr>
              <a:xfrm>
                <a:off x="863640" y="8872920"/>
                <a:ext cx="753480" cy="215640"/>
                <a:chOff x="863640" y="8872920"/>
                <a:chExt cx="753480" cy="215640"/>
              </a:xfrm>
            </p:grpSpPr>
            <p:sp>
              <p:nvSpPr>
                <p:cNvPr id="48" name="Rectangle 109"/>
                <p:cNvSpPr/>
                <p:nvPr/>
              </p:nvSpPr>
              <p:spPr>
                <a:xfrm>
                  <a:off x="1006560" y="8872920"/>
                  <a:ext cx="61056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5760"/>
                      <a:tab algn="l" pos="911160"/>
                      <a:tab algn="l" pos="1366920"/>
                      <a:tab algn="l" pos="1822320"/>
                      <a:tab algn="l" pos="2278080"/>
                      <a:tab algn="l" pos="2733840"/>
                      <a:tab algn="l" pos="3189240"/>
                      <a:tab algn="l" pos="3645000"/>
                      <a:tab algn="l" pos="4100400"/>
                      <a:tab algn="l" pos="4556160"/>
                      <a:tab algn="l" pos="5011560"/>
                      <a:tab algn="l" pos="5467320"/>
                      <a:tab algn="l" pos="5923080"/>
                      <a:tab algn="l" pos="6378480"/>
                      <a:tab algn="l" pos="6834240"/>
                      <a:tab algn="l" pos="7289640"/>
                      <a:tab algn="l" pos="7745400"/>
                      <a:tab algn="l" pos="8201160"/>
                      <a:tab algn="l" pos="8656560"/>
                      <a:tab algn="l" pos="9112320"/>
                    </a:tabLst>
                  </a:pPr>
                  <a:r>
                    <a:rPr b="0" lang="en-US" sz="8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1.31-1.50</a:t>
                  </a:r>
                  <a:endParaRPr b="0" lang="en-US" sz="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49" name="Rounded Rectangle 148"/>
                <p:cNvSpPr/>
                <p:nvPr/>
              </p:nvSpPr>
              <p:spPr>
                <a:xfrm>
                  <a:off x="863640" y="8928360"/>
                  <a:ext cx="182520" cy="109080"/>
                </a:xfrm>
                <a:prstGeom prst="roundRect">
                  <a:avLst>
                    <a:gd name="adj" fmla="val 16667"/>
                  </a:avLst>
                </a:prstGeom>
                <a:solidFill>
                  <a:srgbClr val="fa2606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54720" rIns="54720" tIns="45000" bIns="45000" anchor="ctr">
                  <a:noAutofit/>
                </a:bodyPr>
                <a:p>
                  <a:pPr algn="ctr">
                    <a:lnSpc>
                      <a:spcPct val="9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  <p:grpSp>
            <p:nvGrpSpPr>
              <p:cNvPr id="50" name="Group 111"/>
              <p:cNvGrpSpPr/>
              <p:nvPr/>
            </p:nvGrpSpPr>
            <p:grpSpPr>
              <a:xfrm>
                <a:off x="4776840" y="8872920"/>
                <a:ext cx="753480" cy="215640"/>
                <a:chOff x="4776840" y="8872920"/>
                <a:chExt cx="753480" cy="215640"/>
              </a:xfrm>
            </p:grpSpPr>
            <p:sp>
              <p:nvSpPr>
                <p:cNvPr id="51" name="Rectangle 112"/>
                <p:cNvSpPr/>
                <p:nvPr/>
              </p:nvSpPr>
              <p:spPr>
                <a:xfrm>
                  <a:off x="4919760" y="8872920"/>
                  <a:ext cx="61056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5760"/>
                      <a:tab algn="l" pos="911160"/>
                      <a:tab algn="l" pos="1366920"/>
                      <a:tab algn="l" pos="1822320"/>
                      <a:tab algn="l" pos="2278080"/>
                      <a:tab algn="l" pos="2733840"/>
                      <a:tab algn="l" pos="3189240"/>
                      <a:tab algn="l" pos="3645000"/>
                      <a:tab algn="l" pos="4100400"/>
                      <a:tab algn="l" pos="4556160"/>
                      <a:tab algn="l" pos="5011560"/>
                      <a:tab algn="l" pos="5467320"/>
                      <a:tab algn="l" pos="5923080"/>
                      <a:tab algn="l" pos="6378480"/>
                      <a:tab algn="l" pos="6834240"/>
                      <a:tab algn="l" pos="7289640"/>
                      <a:tab algn="l" pos="7745400"/>
                      <a:tab algn="l" pos="8201160"/>
                      <a:tab algn="l" pos="8656560"/>
                      <a:tab algn="l" pos="9112320"/>
                    </a:tabLst>
                  </a:pPr>
                  <a:r>
                    <a:rPr b="0" lang="en-US" sz="8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0.01-0.50</a:t>
                  </a:r>
                  <a:endParaRPr b="0" lang="en-US" sz="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52" name="Rounded Rectangle 148"/>
                <p:cNvSpPr/>
                <p:nvPr/>
              </p:nvSpPr>
              <p:spPr>
                <a:xfrm>
                  <a:off x="4776840" y="8931240"/>
                  <a:ext cx="182520" cy="109080"/>
                </a:xfrm>
                <a:prstGeom prst="roundRect">
                  <a:avLst>
                    <a:gd name="adj" fmla="val 16667"/>
                  </a:avLst>
                </a:prstGeom>
                <a:solidFill>
                  <a:srgbClr val="003b06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54720" rIns="54720" tIns="45000" bIns="45000" anchor="ctr">
                  <a:noAutofit/>
                </a:bodyPr>
                <a:p>
                  <a:pPr algn="ctr">
                    <a:lnSpc>
                      <a:spcPct val="9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  <p:grpSp>
            <p:nvGrpSpPr>
              <p:cNvPr id="53" name="Group 118"/>
              <p:cNvGrpSpPr/>
              <p:nvPr/>
            </p:nvGrpSpPr>
            <p:grpSpPr>
              <a:xfrm>
                <a:off x="1656720" y="8872920"/>
                <a:ext cx="749880" cy="215640"/>
                <a:chOff x="1656720" y="8872920"/>
                <a:chExt cx="749880" cy="215640"/>
              </a:xfrm>
            </p:grpSpPr>
            <p:sp>
              <p:nvSpPr>
                <p:cNvPr id="54" name="Rectangle 119"/>
                <p:cNvSpPr/>
                <p:nvPr/>
              </p:nvSpPr>
              <p:spPr>
                <a:xfrm>
                  <a:off x="1796040" y="8872920"/>
                  <a:ext cx="61056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5760"/>
                      <a:tab algn="l" pos="911160"/>
                      <a:tab algn="l" pos="1366920"/>
                      <a:tab algn="l" pos="1822320"/>
                      <a:tab algn="l" pos="2278080"/>
                      <a:tab algn="l" pos="2733840"/>
                      <a:tab algn="l" pos="3189240"/>
                      <a:tab algn="l" pos="3645000"/>
                      <a:tab algn="l" pos="4100400"/>
                      <a:tab algn="l" pos="4556160"/>
                      <a:tab algn="l" pos="5011560"/>
                      <a:tab algn="l" pos="5467320"/>
                      <a:tab algn="l" pos="5923080"/>
                      <a:tab algn="l" pos="6378480"/>
                      <a:tab algn="l" pos="6834240"/>
                      <a:tab algn="l" pos="7289640"/>
                      <a:tab algn="l" pos="7745400"/>
                      <a:tab algn="l" pos="8201160"/>
                      <a:tab algn="l" pos="8656560"/>
                      <a:tab algn="l" pos="9112320"/>
                    </a:tabLst>
                  </a:pPr>
                  <a:r>
                    <a:rPr b="0" lang="en-US" sz="8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1.11-1.30</a:t>
                  </a:r>
                  <a:endParaRPr b="0" lang="en-US" sz="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55" name="Rounded Rectangle 148"/>
                <p:cNvSpPr/>
                <p:nvPr/>
              </p:nvSpPr>
              <p:spPr>
                <a:xfrm>
                  <a:off x="1656720" y="8928000"/>
                  <a:ext cx="182160" cy="109080"/>
                </a:xfrm>
                <a:prstGeom prst="roundRect">
                  <a:avLst>
                    <a:gd name="adj" fmla="val 16667"/>
                  </a:avLst>
                </a:prstGeom>
                <a:solidFill>
                  <a:srgbClr val="ffa102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54720" rIns="54720" tIns="45000" bIns="45000" anchor="ctr">
                  <a:noAutofit/>
                </a:bodyPr>
                <a:p>
                  <a:pPr algn="ctr">
                    <a:lnSpc>
                      <a:spcPct val="9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  <p:grpSp>
            <p:nvGrpSpPr>
              <p:cNvPr id="56" name="Group 114"/>
              <p:cNvGrpSpPr/>
              <p:nvPr/>
            </p:nvGrpSpPr>
            <p:grpSpPr>
              <a:xfrm>
                <a:off x="3215160" y="8872920"/>
                <a:ext cx="753480" cy="215640"/>
                <a:chOff x="3215160" y="8872920"/>
                <a:chExt cx="753480" cy="215640"/>
              </a:xfrm>
            </p:grpSpPr>
            <p:sp>
              <p:nvSpPr>
                <p:cNvPr id="57" name="Rectangle 122"/>
                <p:cNvSpPr/>
                <p:nvPr/>
              </p:nvSpPr>
              <p:spPr>
                <a:xfrm>
                  <a:off x="3358080" y="8872920"/>
                  <a:ext cx="61056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5760"/>
                      <a:tab algn="l" pos="911160"/>
                      <a:tab algn="l" pos="1366920"/>
                      <a:tab algn="l" pos="1822320"/>
                      <a:tab algn="l" pos="2278080"/>
                      <a:tab algn="l" pos="2733840"/>
                      <a:tab algn="l" pos="3189240"/>
                      <a:tab algn="l" pos="3645000"/>
                      <a:tab algn="l" pos="4100400"/>
                      <a:tab algn="l" pos="4556160"/>
                      <a:tab algn="l" pos="5011560"/>
                      <a:tab algn="l" pos="5467320"/>
                      <a:tab algn="l" pos="5923080"/>
                      <a:tab algn="l" pos="6378480"/>
                      <a:tab algn="l" pos="6834240"/>
                      <a:tab algn="l" pos="7289640"/>
                      <a:tab algn="l" pos="7745400"/>
                      <a:tab algn="l" pos="8201160"/>
                      <a:tab algn="l" pos="8656560"/>
                      <a:tab algn="l" pos="9112320"/>
                    </a:tabLst>
                  </a:pPr>
                  <a:r>
                    <a:rPr b="0" lang="en-US" sz="8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0.71-0.90</a:t>
                  </a:r>
                  <a:endParaRPr b="0" lang="en-US" sz="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58" name="Rounded Rectangle 148"/>
                <p:cNvSpPr/>
                <p:nvPr/>
              </p:nvSpPr>
              <p:spPr>
                <a:xfrm>
                  <a:off x="3215160" y="8931600"/>
                  <a:ext cx="182520" cy="109440"/>
                </a:xfrm>
                <a:prstGeom prst="roundRect">
                  <a:avLst>
                    <a:gd name="adj" fmla="val 16667"/>
                  </a:avLst>
                </a:prstGeom>
                <a:solidFill>
                  <a:srgbClr val="84ff02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54720" rIns="54720" tIns="45360" bIns="45360" anchor="ctr">
                  <a:noAutofit/>
                </a:bodyPr>
                <a:p>
                  <a:pPr algn="ctr">
                    <a:lnSpc>
                      <a:spcPct val="9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  <p:grpSp>
            <p:nvGrpSpPr>
              <p:cNvPr id="59" name="Group 128"/>
              <p:cNvGrpSpPr/>
              <p:nvPr/>
            </p:nvGrpSpPr>
            <p:grpSpPr>
              <a:xfrm>
                <a:off x="250200" y="8872920"/>
                <a:ext cx="589680" cy="215640"/>
                <a:chOff x="250200" y="8872920"/>
                <a:chExt cx="589680" cy="215640"/>
              </a:xfrm>
            </p:grpSpPr>
            <p:sp>
              <p:nvSpPr>
                <p:cNvPr id="60" name="Rectangle 122"/>
                <p:cNvSpPr/>
                <p:nvPr/>
              </p:nvSpPr>
              <p:spPr>
                <a:xfrm>
                  <a:off x="380520" y="8872920"/>
                  <a:ext cx="45936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5760"/>
                      <a:tab algn="l" pos="911160"/>
                      <a:tab algn="l" pos="1366920"/>
                      <a:tab algn="l" pos="1822320"/>
                      <a:tab algn="l" pos="2278080"/>
                      <a:tab algn="l" pos="2733840"/>
                      <a:tab algn="l" pos="3189240"/>
                      <a:tab algn="l" pos="3645000"/>
                      <a:tab algn="l" pos="4100400"/>
                      <a:tab algn="l" pos="4556160"/>
                      <a:tab algn="l" pos="5011560"/>
                      <a:tab algn="l" pos="5467320"/>
                      <a:tab algn="l" pos="5923080"/>
                      <a:tab algn="l" pos="6378480"/>
                      <a:tab algn="l" pos="6834240"/>
                      <a:tab algn="l" pos="7289640"/>
                      <a:tab algn="l" pos="7745400"/>
                      <a:tab algn="l" pos="8201160"/>
                      <a:tab algn="l" pos="8656560"/>
                      <a:tab algn="l" pos="9112320"/>
                    </a:tabLst>
                  </a:pPr>
                  <a:r>
                    <a:rPr b="0" lang="en-US" sz="800" spc="-1" strike="noStrike">
                      <a:solidFill>
                        <a:srgbClr val="000000"/>
                      </a:solidFill>
                      <a:latin typeface="Symbol"/>
                      <a:ea typeface="Symbol"/>
                    </a:rPr>
                    <a:t></a:t>
                  </a:r>
                  <a:r>
                    <a:rPr b="0" lang="en-US" sz="8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1.51</a:t>
                  </a:r>
                  <a:endParaRPr b="0" lang="en-US" sz="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61" name="Rounded Rectangle 148"/>
                <p:cNvSpPr/>
                <p:nvPr/>
              </p:nvSpPr>
              <p:spPr>
                <a:xfrm>
                  <a:off x="250200" y="8926560"/>
                  <a:ext cx="182160" cy="109440"/>
                </a:xfrm>
                <a:prstGeom prst="roundRect">
                  <a:avLst>
                    <a:gd name="adj" fmla="val 16667"/>
                  </a:avLst>
                </a:prstGeom>
                <a:solidFill>
                  <a:srgbClr val="800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54720" rIns="54720" tIns="45360" bIns="45360" anchor="ctr">
                  <a:noAutofit/>
                </a:bodyPr>
                <a:p>
                  <a:pPr algn="ctr">
                    <a:lnSpc>
                      <a:spcPct val="9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  <p:grpSp>
            <p:nvGrpSpPr>
              <p:cNvPr id="62" name="Group 131"/>
              <p:cNvGrpSpPr/>
              <p:nvPr/>
            </p:nvGrpSpPr>
            <p:grpSpPr>
              <a:xfrm>
                <a:off x="3996000" y="8872920"/>
                <a:ext cx="753480" cy="215640"/>
                <a:chOff x="3996000" y="8872920"/>
                <a:chExt cx="753480" cy="215640"/>
              </a:xfrm>
            </p:grpSpPr>
            <p:sp>
              <p:nvSpPr>
                <p:cNvPr id="63" name="Rectangle 132"/>
                <p:cNvSpPr/>
                <p:nvPr/>
              </p:nvSpPr>
              <p:spPr>
                <a:xfrm>
                  <a:off x="4138920" y="8872920"/>
                  <a:ext cx="61056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5760"/>
                      <a:tab algn="l" pos="911160"/>
                      <a:tab algn="l" pos="1366920"/>
                      <a:tab algn="l" pos="1822320"/>
                      <a:tab algn="l" pos="2278080"/>
                      <a:tab algn="l" pos="2733840"/>
                      <a:tab algn="l" pos="3189240"/>
                      <a:tab algn="l" pos="3645000"/>
                      <a:tab algn="l" pos="4100400"/>
                      <a:tab algn="l" pos="4556160"/>
                      <a:tab algn="l" pos="5011560"/>
                      <a:tab algn="l" pos="5467320"/>
                      <a:tab algn="l" pos="5923080"/>
                      <a:tab algn="l" pos="6378480"/>
                      <a:tab algn="l" pos="6834240"/>
                      <a:tab algn="l" pos="7289640"/>
                      <a:tab algn="l" pos="7745400"/>
                      <a:tab algn="l" pos="8201160"/>
                      <a:tab algn="l" pos="8656560"/>
                      <a:tab algn="l" pos="9112320"/>
                    </a:tabLst>
                  </a:pPr>
                  <a:r>
                    <a:rPr b="0" lang="en-US" sz="8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0.51-0.70</a:t>
                  </a:r>
                  <a:endParaRPr b="0" lang="en-US" sz="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64" name="Rounded Rectangle 148"/>
                <p:cNvSpPr/>
                <p:nvPr/>
              </p:nvSpPr>
              <p:spPr>
                <a:xfrm>
                  <a:off x="3996000" y="8931600"/>
                  <a:ext cx="182520" cy="109440"/>
                </a:xfrm>
                <a:prstGeom prst="roundRect">
                  <a:avLst>
                    <a:gd name="adj" fmla="val 16667"/>
                  </a:avLst>
                </a:prstGeom>
                <a:solidFill>
                  <a:srgbClr val="009601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54720" rIns="54720" tIns="45360" bIns="45360" anchor="ctr">
                  <a:noAutofit/>
                </a:bodyPr>
                <a:p>
                  <a:pPr algn="ctr">
                    <a:lnSpc>
                      <a:spcPct val="9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  <p:grpSp>
            <p:nvGrpSpPr>
              <p:cNvPr id="65" name="Group 111"/>
              <p:cNvGrpSpPr/>
              <p:nvPr/>
            </p:nvGrpSpPr>
            <p:grpSpPr>
              <a:xfrm>
                <a:off x="5551560" y="8872920"/>
                <a:ext cx="1047600" cy="215640"/>
                <a:chOff x="5551560" y="8872920"/>
                <a:chExt cx="1047600" cy="215640"/>
              </a:xfrm>
            </p:grpSpPr>
            <p:sp>
              <p:nvSpPr>
                <p:cNvPr id="66" name="Rectangle 112"/>
                <p:cNvSpPr/>
                <p:nvPr/>
              </p:nvSpPr>
              <p:spPr>
                <a:xfrm>
                  <a:off x="5699160" y="8872920"/>
                  <a:ext cx="90000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5760"/>
                      <a:tab algn="l" pos="911160"/>
                      <a:tab algn="l" pos="1366920"/>
                      <a:tab algn="l" pos="1822320"/>
                      <a:tab algn="l" pos="2278080"/>
                      <a:tab algn="l" pos="2733840"/>
                      <a:tab algn="l" pos="3189240"/>
                      <a:tab algn="l" pos="3645000"/>
                      <a:tab algn="l" pos="4100400"/>
                      <a:tab algn="l" pos="4556160"/>
                      <a:tab algn="l" pos="5011560"/>
                      <a:tab algn="l" pos="5467320"/>
                      <a:tab algn="l" pos="5923080"/>
                      <a:tab algn="l" pos="6378480"/>
                      <a:tab algn="l" pos="6834240"/>
                      <a:tab algn="l" pos="7289640"/>
                      <a:tab algn="l" pos="7745400"/>
                      <a:tab algn="l" pos="8201160"/>
                      <a:tab algn="l" pos="8656560"/>
                      <a:tab algn="l" pos="9112320"/>
                    </a:tabLst>
                  </a:pPr>
                  <a:r>
                    <a:rPr b="0" lang="en-US" sz="8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Not measurable</a:t>
                  </a:r>
                  <a:endParaRPr b="0" lang="en-US" sz="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67" name="Rounded Rectangle 148"/>
                <p:cNvSpPr/>
                <p:nvPr/>
              </p:nvSpPr>
              <p:spPr>
                <a:xfrm>
                  <a:off x="5551560" y="8931240"/>
                  <a:ext cx="182520" cy="109080"/>
                </a:xfrm>
                <a:prstGeom prst="roundRect">
                  <a:avLst>
                    <a:gd name="adj" fmla="val 16667"/>
                  </a:avLst>
                </a:prstGeom>
                <a:solidFill>
                  <a:srgbClr val="a6a6a6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54720" rIns="54720" tIns="45000" bIns="45000" anchor="ctr">
                  <a:noAutofit/>
                </a:bodyPr>
                <a:p>
                  <a:pPr algn="ctr">
                    <a:lnSpc>
                      <a:spcPct val="9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</p:grpSp>
        <p:sp>
          <p:nvSpPr>
            <p:cNvPr id="68" name="TextBox 26"/>
            <p:cNvSpPr/>
            <p:nvPr/>
          </p:nvSpPr>
          <p:spPr>
            <a:xfrm rot="16200000">
              <a:off x="-88920" y="1163160"/>
              <a:ext cx="10126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5760"/>
                  <a:tab algn="l" pos="911160"/>
                  <a:tab algn="l" pos="1366920"/>
                  <a:tab algn="l" pos="1822320"/>
                  <a:tab algn="l" pos="2278080"/>
                  <a:tab algn="l" pos="2733840"/>
                  <a:tab algn="l" pos="3189240"/>
                  <a:tab algn="l" pos="3645000"/>
                  <a:tab algn="l" pos="4100400"/>
                  <a:tab algn="l" pos="4556160"/>
                  <a:tab algn="l" pos="5011560"/>
                  <a:tab algn="l" pos="5467320"/>
                  <a:tab algn="l" pos="5923080"/>
                  <a:tab algn="l" pos="6378480"/>
                  <a:tab algn="l" pos="6834240"/>
                  <a:tab algn="l" pos="7289640"/>
                  <a:tab algn="l" pos="7745400"/>
                  <a:tab algn="l" pos="8201160"/>
                  <a:tab algn="l" pos="8656560"/>
                  <a:tab algn="l" pos="911232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Subcortical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69" name="Picture 6" descr=""/>
            <p:cNvPicPr/>
            <p:nvPr/>
          </p:nvPicPr>
          <p:blipFill>
            <a:blip r:embed="rId1"/>
            <a:srcRect l="0" t="0" r="0" b="10787"/>
            <a:stretch/>
          </p:blipFill>
          <p:spPr>
            <a:xfrm>
              <a:off x="563760" y="483120"/>
              <a:ext cx="1125720" cy="15840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70" name="Picture 8" descr=""/>
            <p:cNvPicPr/>
            <p:nvPr/>
          </p:nvPicPr>
          <p:blipFill>
            <a:blip r:embed="rId2"/>
            <a:srcRect l="0" t="0" r="0" b="11021"/>
            <a:stretch/>
          </p:blipFill>
          <p:spPr>
            <a:xfrm>
              <a:off x="2850480" y="483120"/>
              <a:ext cx="1125720" cy="15840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71" name="Picture 9" descr=""/>
            <p:cNvPicPr/>
            <p:nvPr/>
          </p:nvPicPr>
          <p:blipFill>
            <a:blip r:embed="rId3"/>
            <a:srcRect l="0" t="0" r="0" b="10787"/>
            <a:stretch/>
          </p:blipFill>
          <p:spPr>
            <a:xfrm>
              <a:off x="3993840" y="483120"/>
              <a:ext cx="1125720" cy="15840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72" name="Picture 4" descr=""/>
            <p:cNvPicPr/>
            <p:nvPr/>
          </p:nvPicPr>
          <p:blipFill>
            <a:blip r:embed="rId4"/>
            <a:srcRect l="0" t="0" r="0" b="11029"/>
            <a:stretch/>
          </p:blipFill>
          <p:spPr>
            <a:xfrm>
              <a:off x="1707120" y="483120"/>
              <a:ext cx="1125720" cy="15840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73" name="Picture 5" descr=""/>
            <p:cNvPicPr/>
            <p:nvPr/>
          </p:nvPicPr>
          <p:blipFill>
            <a:blip r:embed="rId5"/>
            <a:srcRect l="0" t="0" r="0" b="11029"/>
            <a:stretch/>
          </p:blipFill>
          <p:spPr>
            <a:xfrm>
              <a:off x="5136840" y="483120"/>
              <a:ext cx="1125720" cy="15840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74" name="TextBox 26"/>
            <p:cNvSpPr/>
            <p:nvPr/>
          </p:nvSpPr>
          <p:spPr>
            <a:xfrm rot="16200000">
              <a:off x="43200" y="3048480"/>
              <a:ext cx="7491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5760"/>
                  <a:tab algn="l" pos="911160"/>
                  <a:tab algn="l" pos="1366920"/>
                  <a:tab algn="l" pos="1822320"/>
                  <a:tab algn="l" pos="2278080"/>
                  <a:tab algn="l" pos="2733840"/>
                  <a:tab algn="l" pos="3189240"/>
                  <a:tab algn="l" pos="3645000"/>
                  <a:tab algn="l" pos="4100400"/>
                  <a:tab algn="l" pos="4556160"/>
                  <a:tab algn="l" pos="5011560"/>
                  <a:tab algn="l" pos="5467320"/>
                  <a:tab algn="l" pos="5923080"/>
                  <a:tab algn="l" pos="6378480"/>
                  <a:tab algn="l" pos="6834240"/>
                  <a:tab algn="l" pos="7289640"/>
                  <a:tab algn="l" pos="7745400"/>
                  <a:tab algn="l" pos="8201160"/>
                  <a:tab algn="l" pos="8656560"/>
                  <a:tab algn="l" pos="911232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Cortical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5" name="Straight Connector 106"/>
            <p:cNvSpPr/>
            <p:nvPr/>
          </p:nvSpPr>
          <p:spPr>
            <a:xfrm>
              <a:off x="601560" y="2211480"/>
              <a:ext cx="57247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76" name="Picture 11" descr=""/>
            <p:cNvPicPr/>
            <p:nvPr/>
          </p:nvPicPr>
          <p:blipFill>
            <a:blip r:embed="rId6"/>
            <a:srcRect l="0" t="0" r="0" b="10820"/>
            <a:stretch/>
          </p:blipFill>
          <p:spPr>
            <a:xfrm>
              <a:off x="563760" y="2335320"/>
              <a:ext cx="1125720" cy="15840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77" name="Picture 12" descr=""/>
            <p:cNvPicPr/>
            <p:nvPr/>
          </p:nvPicPr>
          <p:blipFill>
            <a:blip r:embed="rId7"/>
            <a:srcRect l="0" t="0" r="0" b="10820"/>
            <a:stretch/>
          </p:blipFill>
          <p:spPr>
            <a:xfrm>
              <a:off x="1707120" y="2335320"/>
              <a:ext cx="1125720" cy="15840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78" name="Picture 15" descr=""/>
            <p:cNvPicPr/>
            <p:nvPr/>
          </p:nvPicPr>
          <p:blipFill>
            <a:blip r:embed="rId8"/>
            <a:srcRect l="0" t="0" r="0" b="10595"/>
            <a:stretch/>
          </p:blipFill>
          <p:spPr>
            <a:xfrm>
              <a:off x="3993840" y="2335320"/>
              <a:ext cx="1125720" cy="15840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79" name="Picture 16" descr=""/>
            <p:cNvPicPr/>
            <p:nvPr/>
          </p:nvPicPr>
          <p:blipFill>
            <a:blip r:embed="rId9"/>
            <a:srcRect l="0" t="0" r="0" b="10820"/>
            <a:stretch/>
          </p:blipFill>
          <p:spPr>
            <a:xfrm>
              <a:off x="5136840" y="2335320"/>
              <a:ext cx="1125720" cy="15840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80" name="Picture 7" descr=""/>
            <p:cNvPicPr/>
            <p:nvPr/>
          </p:nvPicPr>
          <p:blipFill>
            <a:blip r:embed="rId10"/>
            <a:srcRect l="0" t="0" r="0" b="10829"/>
            <a:stretch/>
          </p:blipFill>
          <p:spPr>
            <a:xfrm>
              <a:off x="2850480" y="2335320"/>
              <a:ext cx="1125720" cy="15840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81" name="TextBox 26"/>
            <p:cNvSpPr/>
            <p:nvPr/>
          </p:nvSpPr>
          <p:spPr>
            <a:xfrm rot="16200000">
              <a:off x="-87120" y="5457600"/>
              <a:ext cx="10126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5760"/>
                  <a:tab algn="l" pos="911160"/>
                  <a:tab algn="l" pos="1366920"/>
                  <a:tab algn="l" pos="1822320"/>
                  <a:tab algn="l" pos="2278080"/>
                  <a:tab algn="l" pos="2733840"/>
                  <a:tab algn="l" pos="3189240"/>
                  <a:tab algn="l" pos="3645000"/>
                  <a:tab algn="l" pos="4100400"/>
                  <a:tab algn="l" pos="4556160"/>
                  <a:tab algn="l" pos="5011560"/>
                  <a:tab algn="l" pos="5467320"/>
                  <a:tab algn="l" pos="5923080"/>
                  <a:tab algn="l" pos="6378480"/>
                  <a:tab algn="l" pos="6834240"/>
                  <a:tab algn="l" pos="7289640"/>
                  <a:tab algn="l" pos="7745400"/>
                  <a:tab algn="l" pos="8201160"/>
                  <a:tab algn="l" pos="8656560"/>
                  <a:tab algn="l" pos="911232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Subcortical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82" name="Picture 19" descr=""/>
            <p:cNvPicPr/>
            <p:nvPr/>
          </p:nvPicPr>
          <p:blipFill>
            <a:blip r:embed="rId11"/>
            <a:srcRect l="0" t="0" r="0" b="10155"/>
            <a:stretch/>
          </p:blipFill>
          <p:spPr>
            <a:xfrm>
              <a:off x="2850480" y="4750200"/>
              <a:ext cx="1260000" cy="17280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83" name="Picture 21" descr=""/>
            <p:cNvPicPr/>
            <p:nvPr/>
          </p:nvPicPr>
          <p:blipFill>
            <a:blip r:embed="rId12"/>
            <a:srcRect l="0" t="0" r="0" b="10076"/>
            <a:stretch/>
          </p:blipFill>
          <p:spPr>
            <a:xfrm>
              <a:off x="3993840" y="4750200"/>
              <a:ext cx="1260000" cy="17280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84" name="Picture 3" descr=""/>
            <p:cNvPicPr/>
            <p:nvPr/>
          </p:nvPicPr>
          <p:blipFill>
            <a:blip r:embed="rId13"/>
            <a:srcRect l="0" t="0" r="0" b="10092"/>
            <a:stretch/>
          </p:blipFill>
          <p:spPr>
            <a:xfrm>
              <a:off x="563760" y="4750200"/>
              <a:ext cx="1260000" cy="17280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85" name="Picture 4" descr=""/>
            <p:cNvPicPr/>
            <p:nvPr/>
          </p:nvPicPr>
          <p:blipFill>
            <a:blip r:embed="rId14"/>
            <a:srcRect l="0" t="0" r="0" b="10321"/>
            <a:stretch/>
          </p:blipFill>
          <p:spPr>
            <a:xfrm>
              <a:off x="1707120" y="4750200"/>
              <a:ext cx="1260000" cy="17280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86" name="Picture 5" descr=""/>
            <p:cNvPicPr/>
            <p:nvPr/>
          </p:nvPicPr>
          <p:blipFill>
            <a:blip r:embed="rId15"/>
            <a:srcRect l="0" t="0" r="0" b="10550"/>
            <a:stretch/>
          </p:blipFill>
          <p:spPr>
            <a:xfrm>
              <a:off x="5136840" y="4750200"/>
              <a:ext cx="1260000" cy="17280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87" name="TextBox 26"/>
            <p:cNvSpPr/>
            <p:nvPr/>
          </p:nvSpPr>
          <p:spPr>
            <a:xfrm rot="16200000">
              <a:off x="43560" y="7394760"/>
              <a:ext cx="7491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5760"/>
                  <a:tab algn="l" pos="911160"/>
                  <a:tab algn="l" pos="1366920"/>
                  <a:tab algn="l" pos="1822320"/>
                  <a:tab algn="l" pos="2278080"/>
                  <a:tab algn="l" pos="2733840"/>
                  <a:tab algn="l" pos="3189240"/>
                  <a:tab algn="l" pos="3645000"/>
                  <a:tab algn="l" pos="4100400"/>
                  <a:tab algn="l" pos="4556160"/>
                  <a:tab algn="l" pos="5011560"/>
                  <a:tab algn="l" pos="5467320"/>
                  <a:tab algn="l" pos="5923080"/>
                  <a:tab algn="l" pos="6378480"/>
                  <a:tab algn="l" pos="6834240"/>
                  <a:tab algn="l" pos="7289640"/>
                  <a:tab algn="l" pos="7745400"/>
                  <a:tab algn="l" pos="8201160"/>
                  <a:tab algn="l" pos="8656560"/>
                  <a:tab algn="l" pos="911232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Cortical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8" name="Straight Connector 130"/>
            <p:cNvSpPr/>
            <p:nvPr/>
          </p:nvSpPr>
          <p:spPr>
            <a:xfrm>
              <a:off x="601560" y="6564600"/>
              <a:ext cx="57247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89" name="Picture 23" descr=""/>
            <p:cNvPicPr/>
            <p:nvPr/>
          </p:nvPicPr>
          <p:blipFill>
            <a:blip r:embed="rId16"/>
            <a:srcRect l="0" t="0" r="0" b="10178"/>
            <a:stretch/>
          </p:blipFill>
          <p:spPr>
            <a:xfrm>
              <a:off x="563760" y="6672960"/>
              <a:ext cx="1260000" cy="17280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90" name="Picture 24" descr=""/>
            <p:cNvPicPr/>
            <p:nvPr/>
          </p:nvPicPr>
          <p:blipFill>
            <a:blip r:embed="rId17"/>
            <a:srcRect l="0" t="0" r="0" b="10178"/>
            <a:stretch/>
          </p:blipFill>
          <p:spPr>
            <a:xfrm>
              <a:off x="1707120" y="6672960"/>
              <a:ext cx="1260000" cy="17280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91" name="Picture 25" descr=""/>
            <p:cNvPicPr/>
            <p:nvPr/>
          </p:nvPicPr>
          <p:blipFill>
            <a:blip r:embed="rId18"/>
            <a:srcRect l="0" t="0" r="0" b="10486"/>
            <a:stretch/>
          </p:blipFill>
          <p:spPr>
            <a:xfrm>
              <a:off x="2850480" y="6672960"/>
              <a:ext cx="1260000" cy="17280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92" name="Picture 26" descr=""/>
            <p:cNvPicPr/>
            <p:nvPr/>
          </p:nvPicPr>
          <p:blipFill>
            <a:blip r:embed="rId19"/>
            <a:srcRect l="0" t="0" r="0" b="10636"/>
            <a:stretch/>
          </p:blipFill>
          <p:spPr>
            <a:xfrm>
              <a:off x="3993840" y="6672960"/>
              <a:ext cx="1260000" cy="17280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93" name="Picture 7" descr=""/>
            <p:cNvPicPr/>
            <p:nvPr/>
          </p:nvPicPr>
          <p:blipFill>
            <a:blip r:embed="rId20"/>
            <a:srcRect l="0" t="0" r="0" b="10652"/>
            <a:stretch/>
          </p:blipFill>
          <p:spPr>
            <a:xfrm>
              <a:off x="5136840" y="6672960"/>
              <a:ext cx="1260000" cy="17280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94" name="Straight Connector 145"/>
            <p:cNvSpPr/>
            <p:nvPr/>
          </p:nvSpPr>
          <p:spPr>
            <a:xfrm>
              <a:off x="601560" y="8520480"/>
              <a:ext cx="57247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5" name="Straight Connector 146"/>
            <p:cNvSpPr/>
            <p:nvPr/>
          </p:nvSpPr>
          <p:spPr>
            <a:xfrm>
              <a:off x="601560" y="8564760"/>
              <a:ext cx="57247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6" name="TextBox 26"/>
            <p:cNvSpPr/>
            <p:nvPr/>
          </p:nvSpPr>
          <p:spPr>
            <a:xfrm rot="16200000">
              <a:off x="5999760" y="6426000"/>
              <a:ext cx="10965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5760"/>
                  <a:tab algn="l" pos="911160"/>
                  <a:tab algn="l" pos="1366920"/>
                  <a:tab algn="l" pos="1822320"/>
                  <a:tab algn="l" pos="2278080"/>
                  <a:tab algn="l" pos="2733840"/>
                  <a:tab algn="l" pos="3189240"/>
                  <a:tab algn="l" pos="3645000"/>
                  <a:tab algn="l" pos="4100400"/>
                  <a:tab algn="l" pos="4556160"/>
                  <a:tab algn="l" pos="5011560"/>
                  <a:tab algn="l" pos="5467320"/>
                  <a:tab algn="l" pos="5923080"/>
                  <a:tab algn="l" pos="6378480"/>
                  <a:tab algn="l" pos="6834240"/>
                  <a:tab algn="l" pos="7289640"/>
                  <a:tab algn="l" pos="7745400"/>
                  <a:tab algn="l" pos="8201160"/>
                  <a:tab algn="l" pos="8656560"/>
                  <a:tab algn="l" pos="911232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ACTIVATION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7" name="TextBox 26"/>
            <p:cNvSpPr/>
            <p:nvPr/>
          </p:nvSpPr>
          <p:spPr>
            <a:xfrm rot="16200000">
              <a:off x="5960880" y="2070360"/>
              <a:ext cx="11743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5760"/>
                  <a:tab algn="l" pos="911160"/>
                  <a:tab algn="l" pos="1366920"/>
                  <a:tab algn="l" pos="1822320"/>
                  <a:tab algn="l" pos="2278080"/>
                  <a:tab algn="l" pos="2733840"/>
                  <a:tab algn="l" pos="3189240"/>
                  <a:tab algn="l" pos="3645000"/>
                  <a:tab algn="l" pos="4100400"/>
                  <a:tab algn="l" pos="4556160"/>
                  <a:tab algn="l" pos="5011560"/>
                  <a:tab algn="l" pos="5467320"/>
                  <a:tab algn="l" pos="5923080"/>
                  <a:tab algn="l" pos="6378480"/>
                  <a:tab algn="l" pos="6834240"/>
                  <a:tab algn="l" pos="7289640"/>
                  <a:tab algn="l" pos="7745400"/>
                  <a:tab algn="l" pos="8201160"/>
                  <a:tab algn="l" pos="8656560"/>
                  <a:tab algn="l" pos="911232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EXPRESSION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8" name="Straight Connector 88"/>
            <p:cNvSpPr/>
            <p:nvPr/>
          </p:nvSpPr>
          <p:spPr>
            <a:xfrm>
              <a:off x="596880" y="4037040"/>
              <a:ext cx="57261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9" name="Straight Connector 89"/>
            <p:cNvSpPr/>
            <p:nvPr/>
          </p:nvSpPr>
          <p:spPr>
            <a:xfrm>
              <a:off x="601560" y="4081680"/>
              <a:ext cx="57247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grpSp>
          <p:nvGrpSpPr>
            <p:cNvPr id="100" name="Group 3"/>
            <p:cNvGrpSpPr/>
            <p:nvPr/>
          </p:nvGrpSpPr>
          <p:grpSpPr>
            <a:xfrm>
              <a:off x="161280" y="127080"/>
              <a:ext cx="6165000" cy="307080"/>
              <a:chOff x="161280" y="127080"/>
              <a:chExt cx="6165000" cy="307080"/>
            </a:xfrm>
          </p:grpSpPr>
          <p:sp>
            <p:nvSpPr>
              <p:cNvPr id="101" name="TextBox 26"/>
              <p:cNvSpPr/>
              <p:nvPr/>
            </p:nvSpPr>
            <p:spPr>
              <a:xfrm>
                <a:off x="779760" y="139680"/>
                <a:ext cx="56160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5760"/>
                    <a:tab algn="l" pos="911160"/>
                    <a:tab algn="l" pos="1366920"/>
                    <a:tab algn="l" pos="1822320"/>
                    <a:tab algn="l" pos="2278080"/>
                    <a:tab algn="l" pos="2733840"/>
                    <a:tab algn="l" pos="3189240"/>
                    <a:tab algn="l" pos="3645000"/>
                    <a:tab algn="l" pos="4100400"/>
                    <a:tab algn="l" pos="4556160"/>
                    <a:tab algn="l" pos="5011560"/>
                    <a:tab algn="l" pos="5467320"/>
                    <a:tab algn="l" pos="5923080"/>
                    <a:tab algn="l" pos="6378480"/>
                    <a:tab algn="l" pos="6834240"/>
                    <a:tab algn="l" pos="7289640"/>
                    <a:tab algn="l" pos="7745400"/>
                    <a:tab algn="l" pos="8201160"/>
                    <a:tab algn="l" pos="8656560"/>
                    <a:tab algn="l" pos="9112320"/>
                  </a:tabLst>
                </a:pPr>
                <a:r>
                  <a:rPr b="0" lang="en-US" sz="11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70 dpi</a:t>
                </a:r>
                <a:endParaRPr b="0" lang="en-US" sz="11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2" name="TextBox 26"/>
              <p:cNvSpPr/>
              <p:nvPr/>
            </p:nvSpPr>
            <p:spPr>
              <a:xfrm>
                <a:off x="1913760" y="139680"/>
                <a:ext cx="56160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5760"/>
                    <a:tab algn="l" pos="911160"/>
                    <a:tab algn="l" pos="1366920"/>
                    <a:tab algn="l" pos="1822320"/>
                    <a:tab algn="l" pos="2278080"/>
                    <a:tab algn="l" pos="2733840"/>
                    <a:tab algn="l" pos="3189240"/>
                    <a:tab algn="l" pos="3645000"/>
                    <a:tab algn="l" pos="4100400"/>
                    <a:tab algn="l" pos="4556160"/>
                    <a:tab algn="l" pos="5011560"/>
                    <a:tab algn="l" pos="5467320"/>
                    <a:tab algn="l" pos="5923080"/>
                    <a:tab algn="l" pos="6378480"/>
                    <a:tab algn="l" pos="6834240"/>
                    <a:tab algn="l" pos="7289640"/>
                    <a:tab algn="l" pos="7745400"/>
                    <a:tab algn="l" pos="8201160"/>
                    <a:tab algn="l" pos="8656560"/>
                    <a:tab algn="l" pos="9112320"/>
                  </a:tabLst>
                </a:pPr>
                <a:r>
                  <a:rPr b="0" lang="en-US" sz="11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90 dpi</a:t>
                </a:r>
                <a:endParaRPr b="0" lang="en-US" sz="11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3" name="TextBox 26"/>
              <p:cNvSpPr/>
              <p:nvPr/>
            </p:nvSpPr>
            <p:spPr>
              <a:xfrm>
                <a:off x="3016800" y="139680"/>
                <a:ext cx="63936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5760"/>
                    <a:tab algn="l" pos="911160"/>
                    <a:tab algn="l" pos="1366920"/>
                    <a:tab algn="l" pos="1822320"/>
                    <a:tab algn="l" pos="2278080"/>
                    <a:tab algn="l" pos="2733840"/>
                    <a:tab algn="l" pos="3189240"/>
                    <a:tab algn="l" pos="3645000"/>
                    <a:tab algn="l" pos="4100400"/>
                    <a:tab algn="l" pos="4556160"/>
                    <a:tab algn="l" pos="5011560"/>
                    <a:tab algn="l" pos="5467320"/>
                    <a:tab algn="l" pos="5923080"/>
                    <a:tab algn="l" pos="6378480"/>
                    <a:tab algn="l" pos="6834240"/>
                    <a:tab algn="l" pos="7289640"/>
                    <a:tab algn="l" pos="7745400"/>
                    <a:tab algn="l" pos="8201160"/>
                    <a:tab algn="l" pos="8656560"/>
                    <a:tab algn="l" pos="9112320"/>
                  </a:tabLst>
                </a:pPr>
                <a:r>
                  <a:rPr b="0" lang="en-US" sz="11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110 dpi</a:t>
                </a:r>
                <a:endParaRPr b="0" lang="en-US" sz="11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4" name="TextBox 26"/>
              <p:cNvSpPr/>
              <p:nvPr/>
            </p:nvSpPr>
            <p:spPr>
              <a:xfrm>
                <a:off x="4161960" y="139680"/>
                <a:ext cx="63936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5760"/>
                    <a:tab algn="l" pos="911160"/>
                    <a:tab algn="l" pos="1366920"/>
                    <a:tab algn="l" pos="1822320"/>
                    <a:tab algn="l" pos="2278080"/>
                    <a:tab algn="l" pos="2733840"/>
                    <a:tab algn="l" pos="3189240"/>
                    <a:tab algn="l" pos="3645000"/>
                    <a:tab algn="l" pos="4100400"/>
                    <a:tab algn="l" pos="4556160"/>
                    <a:tab algn="l" pos="5011560"/>
                    <a:tab algn="l" pos="5467320"/>
                    <a:tab algn="l" pos="5923080"/>
                    <a:tab algn="l" pos="6378480"/>
                    <a:tab algn="l" pos="6834240"/>
                    <a:tab algn="l" pos="7289640"/>
                    <a:tab algn="l" pos="7745400"/>
                    <a:tab algn="l" pos="8201160"/>
                    <a:tab algn="l" pos="8656560"/>
                    <a:tab algn="l" pos="9112320"/>
                  </a:tabLst>
                </a:pPr>
                <a:r>
                  <a:rPr b="0" lang="en-US" sz="11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130 dpi</a:t>
                </a:r>
                <a:endParaRPr b="0" lang="en-US" sz="11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5" name="TextBox 26"/>
              <p:cNvSpPr/>
              <p:nvPr/>
            </p:nvSpPr>
            <p:spPr>
              <a:xfrm>
                <a:off x="5262840" y="141120"/>
                <a:ext cx="72468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5760"/>
                    <a:tab algn="l" pos="911160"/>
                    <a:tab algn="l" pos="1366920"/>
                    <a:tab algn="l" pos="1822320"/>
                    <a:tab algn="l" pos="2278080"/>
                    <a:tab algn="l" pos="2733840"/>
                    <a:tab algn="l" pos="3189240"/>
                    <a:tab algn="l" pos="3645000"/>
                    <a:tab algn="l" pos="4100400"/>
                    <a:tab algn="l" pos="4556160"/>
                    <a:tab algn="l" pos="5011560"/>
                    <a:tab algn="l" pos="5467320"/>
                    <a:tab algn="l" pos="5923080"/>
                    <a:tab algn="l" pos="6378480"/>
                    <a:tab algn="l" pos="6834240"/>
                    <a:tab algn="l" pos="7289640"/>
                    <a:tab algn="l" pos="7745400"/>
                    <a:tab algn="l" pos="8201160"/>
                    <a:tab algn="l" pos="8656560"/>
                    <a:tab algn="l" pos="9112320"/>
                  </a:tabLst>
                </a:pPr>
                <a:r>
                  <a:rPr b="0" lang="en-US" sz="11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Terminal</a:t>
                </a:r>
                <a:endParaRPr b="0" lang="en-US" sz="11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6" name="TextBox 7"/>
              <p:cNvSpPr/>
              <p:nvPr/>
            </p:nvSpPr>
            <p:spPr>
              <a:xfrm>
                <a:off x="161280" y="127080"/>
                <a:ext cx="35892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5760"/>
                    <a:tab algn="l" pos="911160"/>
                    <a:tab algn="l" pos="1366920"/>
                    <a:tab algn="l" pos="1822320"/>
                    <a:tab algn="l" pos="2278080"/>
                    <a:tab algn="l" pos="2733840"/>
                    <a:tab algn="l" pos="3189240"/>
                    <a:tab algn="l" pos="3645000"/>
                    <a:tab algn="l" pos="4100400"/>
                    <a:tab algn="l" pos="4556160"/>
                    <a:tab algn="l" pos="5011560"/>
                    <a:tab algn="l" pos="5467320"/>
                    <a:tab algn="l" pos="5923080"/>
                    <a:tab algn="l" pos="6378480"/>
                    <a:tab algn="l" pos="6834240"/>
                    <a:tab algn="l" pos="7289640"/>
                    <a:tab algn="l" pos="7745400"/>
                    <a:tab algn="l" pos="8201160"/>
                    <a:tab algn="l" pos="8656560"/>
                    <a:tab algn="l" pos="911232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A.</a:t>
                </a:r>
                <a:endParaRPr b="0" lang="en-US" sz="1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7" name="Straight Connector 92"/>
              <p:cNvSpPr/>
              <p:nvPr/>
            </p:nvSpPr>
            <p:spPr>
              <a:xfrm>
                <a:off x="601560" y="169920"/>
                <a:ext cx="57247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8" name="Straight Connector 93"/>
              <p:cNvSpPr/>
              <p:nvPr/>
            </p:nvSpPr>
            <p:spPr>
              <a:xfrm>
                <a:off x="601560" y="388800"/>
                <a:ext cx="57247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109" name="Group 2"/>
            <p:cNvGrpSpPr/>
            <p:nvPr/>
          </p:nvGrpSpPr>
          <p:grpSpPr>
            <a:xfrm>
              <a:off x="161280" y="4384800"/>
              <a:ext cx="6165000" cy="307080"/>
              <a:chOff x="161280" y="4384800"/>
              <a:chExt cx="6165000" cy="307080"/>
            </a:xfrm>
          </p:grpSpPr>
          <p:sp>
            <p:nvSpPr>
              <p:cNvPr id="110" name="TextBox 26"/>
              <p:cNvSpPr/>
              <p:nvPr/>
            </p:nvSpPr>
            <p:spPr>
              <a:xfrm>
                <a:off x="779760" y="4397400"/>
                <a:ext cx="56160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5760"/>
                    <a:tab algn="l" pos="911160"/>
                    <a:tab algn="l" pos="1366920"/>
                    <a:tab algn="l" pos="1822320"/>
                    <a:tab algn="l" pos="2278080"/>
                    <a:tab algn="l" pos="2733840"/>
                    <a:tab algn="l" pos="3189240"/>
                    <a:tab algn="l" pos="3645000"/>
                    <a:tab algn="l" pos="4100400"/>
                    <a:tab algn="l" pos="4556160"/>
                    <a:tab algn="l" pos="5011560"/>
                    <a:tab algn="l" pos="5467320"/>
                    <a:tab algn="l" pos="5923080"/>
                    <a:tab algn="l" pos="6378480"/>
                    <a:tab algn="l" pos="6834240"/>
                    <a:tab algn="l" pos="7289640"/>
                    <a:tab algn="l" pos="7745400"/>
                    <a:tab algn="l" pos="8201160"/>
                    <a:tab algn="l" pos="8656560"/>
                    <a:tab algn="l" pos="9112320"/>
                  </a:tabLst>
                </a:pPr>
                <a:r>
                  <a:rPr b="0" lang="en-US" sz="11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70 dpi</a:t>
                </a:r>
                <a:endParaRPr b="0" lang="en-US" sz="11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1" name="TextBox 26"/>
              <p:cNvSpPr/>
              <p:nvPr/>
            </p:nvSpPr>
            <p:spPr>
              <a:xfrm>
                <a:off x="1913760" y="4397400"/>
                <a:ext cx="56160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5760"/>
                    <a:tab algn="l" pos="911160"/>
                    <a:tab algn="l" pos="1366920"/>
                    <a:tab algn="l" pos="1822320"/>
                    <a:tab algn="l" pos="2278080"/>
                    <a:tab algn="l" pos="2733840"/>
                    <a:tab algn="l" pos="3189240"/>
                    <a:tab algn="l" pos="3645000"/>
                    <a:tab algn="l" pos="4100400"/>
                    <a:tab algn="l" pos="4556160"/>
                    <a:tab algn="l" pos="5011560"/>
                    <a:tab algn="l" pos="5467320"/>
                    <a:tab algn="l" pos="5923080"/>
                    <a:tab algn="l" pos="6378480"/>
                    <a:tab algn="l" pos="6834240"/>
                    <a:tab algn="l" pos="7289640"/>
                    <a:tab algn="l" pos="7745400"/>
                    <a:tab algn="l" pos="8201160"/>
                    <a:tab algn="l" pos="8656560"/>
                    <a:tab algn="l" pos="9112320"/>
                  </a:tabLst>
                </a:pPr>
                <a:r>
                  <a:rPr b="0" lang="en-US" sz="11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90 dpi</a:t>
                </a:r>
                <a:endParaRPr b="0" lang="en-US" sz="11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2" name="TextBox 26"/>
              <p:cNvSpPr/>
              <p:nvPr/>
            </p:nvSpPr>
            <p:spPr>
              <a:xfrm>
                <a:off x="3016800" y="4397400"/>
                <a:ext cx="63936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5760"/>
                    <a:tab algn="l" pos="911160"/>
                    <a:tab algn="l" pos="1366920"/>
                    <a:tab algn="l" pos="1822320"/>
                    <a:tab algn="l" pos="2278080"/>
                    <a:tab algn="l" pos="2733840"/>
                    <a:tab algn="l" pos="3189240"/>
                    <a:tab algn="l" pos="3645000"/>
                    <a:tab algn="l" pos="4100400"/>
                    <a:tab algn="l" pos="4556160"/>
                    <a:tab algn="l" pos="5011560"/>
                    <a:tab algn="l" pos="5467320"/>
                    <a:tab algn="l" pos="5923080"/>
                    <a:tab algn="l" pos="6378480"/>
                    <a:tab algn="l" pos="6834240"/>
                    <a:tab algn="l" pos="7289640"/>
                    <a:tab algn="l" pos="7745400"/>
                    <a:tab algn="l" pos="8201160"/>
                    <a:tab algn="l" pos="8656560"/>
                    <a:tab algn="l" pos="9112320"/>
                  </a:tabLst>
                </a:pPr>
                <a:r>
                  <a:rPr b="0" lang="en-US" sz="11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110 dpi</a:t>
                </a:r>
                <a:endParaRPr b="0" lang="en-US" sz="11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3" name="TextBox 26"/>
              <p:cNvSpPr/>
              <p:nvPr/>
            </p:nvSpPr>
            <p:spPr>
              <a:xfrm>
                <a:off x="4161960" y="4397400"/>
                <a:ext cx="63936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5760"/>
                    <a:tab algn="l" pos="911160"/>
                    <a:tab algn="l" pos="1366920"/>
                    <a:tab algn="l" pos="1822320"/>
                    <a:tab algn="l" pos="2278080"/>
                    <a:tab algn="l" pos="2733840"/>
                    <a:tab algn="l" pos="3189240"/>
                    <a:tab algn="l" pos="3645000"/>
                    <a:tab algn="l" pos="4100400"/>
                    <a:tab algn="l" pos="4556160"/>
                    <a:tab algn="l" pos="5011560"/>
                    <a:tab algn="l" pos="5467320"/>
                    <a:tab algn="l" pos="5923080"/>
                    <a:tab algn="l" pos="6378480"/>
                    <a:tab algn="l" pos="6834240"/>
                    <a:tab algn="l" pos="7289640"/>
                    <a:tab algn="l" pos="7745400"/>
                    <a:tab algn="l" pos="8201160"/>
                    <a:tab algn="l" pos="8656560"/>
                    <a:tab algn="l" pos="9112320"/>
                  </a:tabLst>
                </a:pPr>
                <a:r>
                  <a:rPr b="0" lang="en-US" sz="11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130 dpi</a:t>
                </a:r>
                <a:endParaRPr b="0" lang="en-US" sz="11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4" name="TextBox 26"/>
              <p:cNvSpPr/>
              <p:nvPr/>
            </p:nvSpPr>
            <p:spPr>
              <a:xfrm>
                <a:off x="5262840" y="4398840"/>
                <a:ext cx="72468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5760"/>
                    <a:tab algn="l" pos="911160"/>
                    <a:tab algn="l" pos="1366920"/>
                    <a:tab algn="l" pos="1822320"/>
                    <a:tab algn="l" pos="2278080"/>
                    <a:tab algn="l" pos="2733840"/>
                    <a:tab algn="l" pos="3189240"/>
                    <a:tab algn="l" pos="3645000"/>
                    <a:tab algn="l" pos="4100400"/>
                    <a:tab algn="l" pos="4556160"/>
                    <a:tab algn="l" pos="5011560"/>
                    <a:tab algn="l" pos="5467320"/>
                    <a:tab algn="l" pos="5923080"/>
                    <a:tab algn="l" pos="6378480"/>
                    <a:tab algn="l" pos="6834240"/>
                    <a:tab algn="l" pos="7289640"/>
                    <a:tab algn="l" pos="7745400"/>
                    <a:tab algn="l" pos="8201160"/>
                    <a:tab algn="l" pos="8656560"/>
                    <a:tab algn="l" pos="9112320"/>
                  </a:tabLst>
                </a:pPr>
                <a:r>
                  <a:rPr b="0" lang="en-US" sz="11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Terminal</a:t>
                </a:r>
                <a:endParaRPr b="0" lang="en-US" sz="11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5" name="TextBox 7"/>
              <p:cNvSpPr/>
              <p:nvPr/>
            </p:nvSpPr>
            <p:spPr>
              <a:xfrm>
                <a:off x="161280" y="4384800"/>
                <a:ext cx="35892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5760"/>
                    <a:tab algn="l" pos="911160"/>
                    <a:tab algn="l" pos="1366920"/>
                    <a:tab algn="l" pos="1822320"/>
                    <a:tab algn="l" pos="2278080"/>
                    <a:tab algn="l" pos="2733840"/>
                    <a:tab algn="l" pos="3189240"/>
                    <a:tab algn="l" pos="3645000"/>
                    <a:tab algn="l" pos="4100400"/>
                    <a:tab algn="l" pos="4556160"/>
                    <a:tab algn="l" pos="5011560"/>
                    <a:tab algn="l" pos="5467320"/>
                    <a:tab algn="l" pos="5923080"/>
                    <a:tab algn="l" pos="6378480"/>
                    <a:tab algn="l" pos="6834240"/>
                    <a:tab algn="l" pos="7289640"/>
                    <a:tab algn="l" pos="7745400"/>
                    <a:tab algn="l" pos="8201160"/>
                    <a:tab algn="l" pos="8656560"/>
                    <a:tab algn="l" pos="911232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B.</a:t>
                </a:r>
                <a:endParaRPr b="0" lang="en-US" sz="1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6" name="Straight Connector 101"/>
              <p:cNvSpPr/>
              <p:nvPr/>
            </p:nvSpPr>
            <p:spPr>
              <a:xfrm>
                <a:off x="601560" y="4427280"/>
                <a:ext cx="57247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7" name="Straight Connector 102"/>
              <p:cNvSpPr/>
              <p:nvPr/>
            </p:nvSpPr>
            <p:spPr>
              <a:xfrm>
                <a:off x="601560" y="4646520"/>
                <a:ext cx="57247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18" name="Group 3"/>
          <p:cNvGrpSpPr/>
          <p:nvPr/>
        </p:nvGrpSpPr>
        <p:grpSpPr>
          <a:xfrm>
            <a:off x="250920" y="87480"/>
            <a:ext cx="6348240" cy="9001080"/>
            <a:chOff x="250920" y="87480"/>
            <a:chExt cx="6348240" cy="9001080"/>
          </a:xfrm>
        </p:grpSpPr>
        <p:sp>
          <p:nvSpPr>
            <p:cNvPr id="119" name="TextBox 26"/>
            <p:cNvSpPr/>
            <p:nvPr/>
          </p:nvSpPr>
          <p:spPr>
            <a:xfrm>
              <a:off x="2934360" y="344520"/>
              <a:ext cx="10126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5760"/>
                  <a:tab algn="l" pos="911160"/>
                  <a:tab algn="l" pos="1366920"/>
                  <a:tab algn="l" pos="1822320"/>
                  <a:tab algn="l" pos="2278080"/>
                  <a:tab algn="l" pos="2733840"/>
                  <a:tab algn="l" pos="3189240"/>
                  <a:tab algn="l" pos="3645000"/>
                  <a:tab algn="l" pos="4100400"/>
                  <a:tab algn="l" pos="4556160"/>
                  <a:tab algn="l" pos="5011560"/>
                  <a:tab algn="l" pos="5467320"/>
                  <a:tab algn="l" pos="5923080"/>
                  <a:tab algn="l" pos="6378480"/>
                  <a:tab algn="l" pos="6834240"/>
                  <a:tab algn="l" pos="7289640"/>
                  <a:tab algn="l" pos="7745400"/>
                  <a:tab algn="l" pos="8201160"/>
                  <a:tab algn="l" pos="8656560"/>
                  <a:tab algn="l" pos="911232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Subcortical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0" name="Straight Connector 93"/>
            <p:cNvSpPr/>
            <p:nvPr/>
          </p:nvSpPr>
          <p:spPr>
            <a:xfrm>
              <a:off x="1011240" y="352440"/>
              <a:ext cx="48592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1" name="TextBox 26"/>
            <p:cNvSpPr/>
            <p:nvPr/>
          </p:nvSpPr>
          <p:spPr>
            <a:xfrm>
              <a:off x="1053000" y="546840"/>
              <a:ext cx="5238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5760"/>
                  <a:tab algn="l" pos="911160"/>
                  <a:tab algn="l" pos="1366920"/>
                  <a:tab algn="l" pos="1822320"/>
                  <a:tab algn="l" pos="2278080"/>
                  <a:tab algn="l" pos="2733840"/>
                  <a:tab algn="l" pos="3189240"/>
                  <a:tab algn="l" pos="3645000"/>
                  <a:tab algn="l" pos="4100400"/>
                  <a:tab algn="l" pos="4556160"/>
                  <a:tab algn="l" pos="5011560"/>
                  <a:tab algn="l" pos="5467320"/>
                  <a:tab algn="l" pos="5923080"/>
                  <a:tab algn="l" pos="6378480"/>
                  <a:tab algn="l" pos="6834240"/>
                  <a:tab algn="l" pos="7289640"/>
                  <a:tab algn="l" pos="7745400"/>
                  <a:tab algn="l" pos="8201160"/>
                  <a:tab algn="l" pos="8656560"/>
                  <a:tab algn="l" pos="911232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70 dpi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2" name="TextBox 26"/>
            <p:cNvSpPr/>
            <p:nvPr/>
          </p:nvSpPr>
          <p:spPr>
            <a:xfrm>
              <a:off x="1987560" y="546840"/>
              <a:ext cx="5238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5760"/>
                  <a:tab algn="l" pos="911160"/>
                  <a:tab algn="l" pos="1366920"/>
                  <a:tab algn="l" pos="1822320"/>
                  <a:tab algn="l" pos="2278080"/>
                  <a:tab algn="l" pos="2733840"/>
                  <a:tab algn="l" pos="3189240"/>
                  <a:tab algn="l" pos="3645000"/>
                  <a:tab algn="l" pos="4100400"/>
                  <a:tab algn="l" pos="4556160"/>
                  <a:tab algn="l" pos="5011560"/>
                  <a:tab algn="l" pos="5467320"/>
                  <a:tab algn="l" pos="5923080"/>
                  <a:tab algn="l" pos="6378480"/>
                  <a:tab algn="l" pos="6834240"/>
                  <a:tab algn="l" pos="7289640"/>
                  <a:tab algn="l" pos="7745400"/>
                  <a:tab algn="l" pos="8201160"/>
                  <a:tab algn="l" pos="8656560"/>
                  <a:tab algn="l" pos="911232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90 dpi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3" name="TextBox 26"/>
            <p:cNvSpPr/>
            <p:nvPr/>
          </p:nvSpPr>
          <p:spPr>
            <a:xfrm>
              <a:off x="2881800" y="546840"/>
              <a:ext cx="5936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5760"/>
                  <a:tab algn="l" pos="911160"/>
                  <a:tab algn="l" pos="1366920"/>
                  <a:tab algn="l" pos="1822320"/>
                  <a:tab algn="l" pos="2278080"/>
                  <a:tab algn="l" pos="2733840"/>
                  <a:tab algn="l" pos="3189240"/>
                  <a:tab algn="l" pos="3645000"/>
                  <a:tab algn="l" pos="4100400"/>
                  <a:tab algn="l" pos="4556160"/>
                  <a:tab algn="l" pos="5011560"/>
                  <a:tab algn="l" pos="5467320"/>
                  <a:tab algn="l" pos="5923080"/>
                  <a:tab algn="l" pos="6378480"/>
                  <a:tab algn="l" pos="6834240"/>
                  <a:tab algn="l" pos="7289640"/>
                  <a:tab algn="l" pos="7745400"/>
                  <a:tab algn="l" pos="8201160"/>
                  <a:tab algn="l" pos="8656560"/>
                  <a:tab algn="l" pos="911232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110 dpi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4" name="TextBox 26"/>
            <p:cNvSpPr/>
            <p:nvPr/>
          </p:nvSpPr>
          <p:spPr>
            <a:xfrm>
              <a:off x="3823920" y="546840"/>
              <a:ext cx="5936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5760"/>
                  <a:tab algn="l" pos="911160"/>
                  <a:tab algn="l" pos="1366920"/>
                  <a:tab algn="l" pos="1822320"/>
                  <a:tab algn="l" pos="2278080"/>
                  <a:tab algn="l" pos="2733840"/>
                  <a:tab algn="l" pos="3189240"/>
                  <a:tab algn="l" pos="3645000"/>
                  <a:tab algn="l" pos="4100400"/>
                  <a:tab algn="l" pos="4556160"/>
                  <a:tab algn="l" pos="5011560"/>
                  <a:tab algn="l" pos="5467320"/>
                  <a:tab algn="l" pos="5923080"/>
                  <a:tab algn="l" pos="6378480"/>
                  <a:tab algn="l" pos="6834240"/>
                  <a:tab algn="l" pos="7289640"/>
                  <a:tab algn="l" pos="7745400"/>
                  <a:tab algn="l" pos="8201160"/>
                  <a:tab algn="l" pos="8656560"/>
                  <a:tab algn="l" pos="911232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130 dpi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5" name="TextBox 26"/>
            <p:cNvSpPr/>
            <p:nvPr/>
          </p:nvSpPr>
          <p:spPr>
            <a:xfrm>
              <a:off x="4711680" y="547560"/>
              <a:ext cx="6714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5760"/>
                  <a:tab algn="l" pos="911160"/>
                  <a:tab algn="l" pos="1366920"/>
                  <a:tab algn="l" pos="1822320"/>
                  <a:tab algn="l" pos="2278080"/>
                  <a:tab algn="l" pos="2733840"/>
                  <a:tab algn="l" pos="3189240"/>
                  <a:tab algn="l" pos="3645000"/>
                  <a:tab algn="l" pos="4100400"/>
                  <a:tab algn="l" pos="4556160"/>
                  <a:tab algn="l" pos="5011560"/>
                  <a:tab algn="l" pos="5467320"/>
                  <a:tab algn="l" pos="5923080"/>
                  <a:tab algn="l" pos="6378480"/>
                  <a:tab algn="l" pos="6834240"/>
                  <a:tab algn="l" pos="7289640"/>
                  <a:tab algn="l" pos="7745400"/>
                  <a:tab algn="l" pos="8201160"/>
                  <a:tab algn="l" pos="8656560"/>
                  <a:tab algn="l" pos="911232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Terminal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126" name="Picture 6" descr=""/>
            <p:cNvPicPr/>
            <p:nvPr/>
          </p:nvPicPr>
          <p:blipFill>
            <a:blip r:embed="rId1"/>
            <a:srcRect l="0" t="0" r="0" b="10787"/>
            <a:stretch/>
          </p:blipFill>
          <p:spPr>
            <a:xfrm>
              <a:off x="913680" y="777600"/>
              <a:ext cx="972000" cy="13665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27" name="Picture 8" descr=""/>
            <p:cNvPicPr/>
            <p:nvPr/>
          </p:nvPicPr>
          <p:blipFill>
            <a:blip r:embed="rId2"/>
            <a:srcRect l="0" t="0" r="0" b="11021"/>
            <a:stretch/>
          </p:blipFill>
          <p:spPr>
            <a:xfrm>
              <a:off x="2783880" y="777600"/>
              <a:ext cx="972000" cy="13629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28" name="Picture 9" descr=""/>
            <p:cNvPicPr/>
            <p:nvPr/>
          </p:nvPicPr>
          <p:blipFill>
            <a:blip r:embed="rId3"/>
            <a:srcRect l="0" t="0" r="0" b="10787"/>
            <a:stretch/>
          </p:blipFill>
          <p:spPr>
            <a:xfrm>
              <a:off x="3718800" y="777600"/>
              <a:ext cx="972000" cy="13665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29" name="Picture 4" descr=""/>
            <p:cNvPicPr/>
            <p:nvPr/>
          </p:nvPicPr>
          <p:blipFill>
            <a:blip r:embed="rId4"/>
            <a:srcRect l="0" t="0" r="0" b="11029"/>
            <a:stretch/>
          </p:blipFill>
          <p:spPr>
            <a:xfrm>
              <a:off x="1848960" y="777600"/>
              <a:ext cx="972000" cy="13629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30" name="Picture 5" descr=""/>
            <p:cNvPicPr/>
            <p:nvPr/>
          </p:nvPicPr>
          <p:blipFill>
            <a:blip r:embed="rId5"/>
            <a:srcRect l="0" t="0" r="0" b="11029"/>
            <a:stretch/>
          </p:blipFill>
          <p:spPr>
            <a:xfrm>
              <a:off x="4653720" y="777600"/>
              <a:ext cx="972000" cy="13629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31" name="TextBox 26"/>
            <p:cNvSpPr/>
            <p:nvPr/>
          </p:nvSpPr>
          <p:spPr>
            <a:xfrm>
              <a:off x="3066120" y="2221200"/>
              <a:ext cx="7491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5760"/>
                  <a:tab algn="l" pos="911160"/>
                  <a:tab algn="l" pos="1366920"/>
                  <a:tab algn="l" pos="1822320"/>
                  <a:tab algn="l" pos="2278080"/>
                  <a:tab algn="l" pos="2733840"/>
                  <a:tab algn="l" pos="3189240"/>
                  <a:tab algn="l" pos="3645000"/>
                  <a:tab algn="l" pos="4100400"/>
                  <a:tab algn="l" pos="4556160"/>
                  <a:tab algn="l" pos="5011560"/>
                  <a:tab algn="l" pos="5467320"/>
                  <a:tab algn="l" pos="5923080"/>
                  <a:tab algn="l" pos="6378480"/>
                  <a:tab algn="l" pos="6834240"/>
                  <a:tab algn="l" pos="7289640"/>
                  <a:tab algn="l" pos="7745400"/>
                  <a:tab algn="l" pos="8201160"/>
                  <a:tab algn="l" pos="8656560"/>
                  <a:tab algn="l" pos="911232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Cortical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2" name="Straight Connector 106"/>
            <p:cNvSpPr/>
            <p:nvPr/>
          </p:nvSpPr>
          <p:spPr>
            <a:xfrm>
              <a:off x="1003320" y="2244960"/>
              <a:ext cx="45720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3" name="TextBox 26"/>
            <p:cNvSpPr/>
            <p:nvPr/>
          </p:nvSpPr>
          <p:spPr>
            <a:xfrm>
              <a:off x="1053000" y="2423520"/>
              <a:ext cx="5238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5760"/>
                  <a:tab algn="l" pos="911160"/>
                  <a:tab algn="l" pos="1366920"/>
                  <a:tab algn="l" pos="1822320"/>
                  <a:tab algn="l" pos="2278080"/>
                  <a:tab algn="l" pos="2733840"/>
                  <a:tab algn="l" pos="3189240"/>
                  <a:tab algn="l" pos="3645000"/>
                  <a:tab algn="l" pos="4100400"/>
                  <a:tab algn="l" pos="4556160"/>
                  <a:tab algn="l" pos="5011560"/>
                  <a:tab algn="l" pos="5467320"/>
                  <a:tab algn="l" pos="5923080"/>
                  <a:tab algn="l" pos="6378480"/>
                  <a:tab algn="l" pos="6834240"/>
                  <a:tab algn="l" pos="7289640"/>
                  <a:tab algn="l" pos="7745400"/>
                  <a:tab algn="l" pos="8201160"/>
                  <a:tab algn="l" pos="8656560"/>
                  <a:tab algn="l" pos="911232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70 dpi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4" name="TextBox 26"/>
            <p:cNvSpPr/>
            <p:nvPr/>
          </p:nvSpPr>
          <p:spPr>
            <a:xfrm>
              <a:off x="1987560" y="2423520"/>
              <a:ext cx="5238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5760"/>
                  <a:tab algn="l" pos="911160"/>
                  <a:tab algn="l" pos="1366920"/>
                  <a:tab algn="l" pos="1822320"/>
                  <a:tab algn="l" pos="2278080"/>
                  <a:tab algn="l" pos="2733840"/>
                  <a:tab algn="l" pos="3189240"/>
                  <a:tab algn="l" pos="3645000"/>
                  <a:tab algn="l" pos="4100400"/>
                  <a:tab algn="l" pos="4556160"/>
                  <a:tab algn="l" pos="5011560"/>
                  <a:tab algn="l" pos="5467320"/>
                  <a:tab algn="l" pos="5923080"/>
                  <a:tab algn="l" pos="6378480"/>
                  <a:tab algn="l" pos="6834240"/>
                  <a:tab algn="l" pos="7289640"/>
                  <a:tab algn="l" pos="7745400"/>
                  <a:tab algn="l" pos="8201160"/>
                  <a:tab algn="l" pos="8656560"/>
                  <a:tab algn="l" pos="911232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90 dpi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5" name="TextBox 26"/>
            <p:cNvSpPr/>
            <p:nvPr/>
          </p:nvSpPr>
          <p:spPr>
            <a:xfrm>
              <a:off x="2881800" y="2423520"/>
              <a:ext cx="5936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5760"/>
                  <a:tab algn="l" pos="911160"/>
                  <a:tab algn="l" pos="1366920"/>
                  <a:tab algn="l" pos="1822320"/>
                  <a:tab algn="l" pos="2278080"/>
                  <a:tab algn="l" pos="2733840"/>
                  <a:tab algn="l" pos="3189240"/>
                  <a:tab algn="l" pos="3645000"/>
                  <a:tab algn="l" pos="4100400"/>
                  <a:tab algn="l" pos="4556160"/>
                  <a:tab algn="l" pos="5011560"/>
                  <a:tab algn="l" pos="5467320"/>
                  <a:tab algn="l" pos="5923080"/>
                  <a:tab algn="l" pos="6378480"/>
                  <a:tab algn="l" pos="6834240"/>
                  <a:tab algn="l" pos="7289640"/>
                  <a:tab algn="l" pos="7745400"/>
                  <a:tab algn="l" pos="8201160"/>
                  <a:tab algn="l" pos="8656560"/>
                  <a:tab algn="l" pos="911232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110 dpi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6" name="TextBox 26"/>
            <p:cNvSpPr/>
            <p:nvPr/>
          </p:nvSpPr>
          <p:spPr>
            <a:xfrm>
              <a:off x="3823920" y="2423520"/>
              <a:ext cx="5936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5760"/>
                  <a:tab algn="l" pos="911160"/>
                  <a:tab algn="l" pos="1366920"/>
                  <a:tab algn="l" pos="1822320"/>
                  <a:tab algn="l" pos="2278080"/>
                  <a:tab algn="l" pos="2733840"/>
                  <a:tab algn="l" pos="3189240"/>
                  <a:tab algn="l" pos="3645000"/>
                  <a:tab algn="l" pos="4100400"/>
                  <a:tab algn="l" pos="4556160"/>
                  <a:tab algn="l" pos="5011560"/>
                  <a:tab algn="l" pos="5467320"/>
                  <a:tab algn="l" pos="5923080"/>
                  <a:tab algn="l" pos="6378480"/>
                  <a:tab algn="l" pos="6834240"/>
                  <a:tab algn="l" pos="7289640"/>
                  <a:tab algn="l" pos="7745400"/>
                  <a:tab algn="l" pos="8201160"/>
                  <a:tab algn="l" pos="8656560"/>
                  <a:tab algn="l" pos="911232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130 dpi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7" name="TextBox 26"/>
            <p:cNvSpPr/>
            <p:nvPr/>
          </p:nvSpPr>
          <p:spPr>
            <a:xfrm>
              <a:off x="4711680" y="2422440"/>
              <a:ext cx="6714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5760"/>
                  <a:tab algn="l" pos="911160"/>
                  <a:tab algn="l" pos="1366920"/>
                  <a:tab algn="l" pos="1822320"/>
                  <a:tab algn="l" pos="2278080"/>
                  <a:tab algn="l" pos="2733840"/>
                  <a:tab algn="l" pos="3189240"/>
                  <a:tab algn="l" pos="3645000"/>
                  <a:tab algn="l" pos="4100400"/>
                  <a:tab algn="l" pos="4556160"/>
                  <a:tab algn="l" pos="5011560"/>
                  <a:tab algn="l" pos="5467320"/>
                  <a:tab algn="l" pos="5923080"/>
                  <a:tab algn="l" pos="6378480"/>
                  <a:tab algn="l" pos="6834240"/>
                  <a:tab algn="l" pos="7289640"/>
                  <a:tab algn="l" pos="7745400"/>
                  <a:tab algn="l" pos="8201160"/>
                  <a:tab algn="l" pos="8656560"/>
                  <a:tab algn="l" pos="911232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Terminal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138" name="Picture 11" descr=""/>
            <p:cNvPicPr/>
            <p:nvPr/>
          </p:nvPicPr>
          <p:blipFill>
            <a:blip r:embed="rId6"/>
            <a:srcRect l="0" t="0" r="0" b="10820"/>
            <a:stretch/>
          </p:blipFill>
          <p:spPr>
            <a:xfrm>
              <a:off x="913680" y="2718720"/>
              <a:ext cx="972000" cy="13658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39" name="Picture 12" descr=""/>
            <p:cNvPicPr/>
            <p:nvPr/>
          </p:nvPicPr>
          <p:blipFill>
            <a:blip r:embed="rId7"/>
            <a:srcRect l="0" t="0" r="0" b="10820"/>
            <a:stretch/>
          </p:blipFill>
          <p:spPr>
            <a:xfrm>
              <a:off x="1848960" y="2718720"/>
              <a:ext cx="972000" cy="13658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40" name="Picture 15" descr=""/>
            <p:cNvPicPr/>
            <p:nvPr/>
          </p:nvPicPr>
          <p:blipFill>
            <a:blip r:embed="rId8"/>
            <a:srcRect l="0" t="0" r="0" b="10595"/>
            <a:stretch/>
          </p:blipFill>
          <p:spPr>
            <a:xfrm>
              <a:off x="3718800" y="2718720"/>
              <a:ext cx="972000" cy="13690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41" name="Picture 16" descr=""/>
            <p:cNvPicPr/>
            <p:nvPr/>
          </p:nvPicPr>
          <p:blipFill>
            <a:blip r:embed="rId9"/>
            <a:srcRect l="0" t="0" r="0" b="10820"/>
            <a:stretch/>
          </p:blipFill>
          <p:spPr>
            <a:xfrm>
              <a:off x="4653720" y="2718720"/>
              <a:ext cx="972000" cy="13658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42" name="Picture 7" descr=""/>
            <p:cNvPicPr/>
            <p:nvPr/>
          </p:nvPicPr>
          <p:blipFill>
            <a:blip r:embed="rId10"/>
            <a:srcRect l="0" t="0" r="0" b="10829"/>
            <a:stretch/>
          </p:blipFill>
          <p:spPr>
            <a:xfrm>
              <a:off x="2783880" y="2718720"/>
              <a:ext cx="972000" cy="13658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43" name="TextBox 26"/>
            <p:cNvSpPr/>
            <p:nvPr/>
          </p:nvSpPr>
          <p:spPr>
            <a:xfrm>
              <a:off x="2931120" y="4715280"/>
              <a:ext cx="10126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5760"/>
                  <a:tab algn="l" pos="911160"/>
                  <a:tab algn="l" pos="1366920"/>
                  <a:tab algn="l" pos="1822320"/>
                  <a:tab algn="l" pos="2278080"/>
                  <a:tab algn="l" pos="2733840"/>
                  <a:tab algn="l" pos="3189240"/>
                  <a:tab algn="l" pos="3645000"/>
                  <a:tab algn="l" pos="4100400"/>
                  <a:tab algn="l" pos="4556160"/>
                  <a:tab algn="l" pos="5011560"/>
                  <a:tab algn="l" pos="5467320"/>
                  <a:tab algn="l" pos="5923080"/>
                  <a:tab algn="l" pos="6378480"/>
                  <a:tab algn="l" pos="6834240"/>
                  <a:tab algn="l" pos="7289640"/>
                  <a:tab algn="l" pos="7745400"/>
                  <a:tab algn="l" pos="8201160"/>
                  <a:tab algn="l" pos="8656560"/>
                  <a:tab algn="l" pos="911232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Subcortical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4" name="Straight Connector 118"/>
            <p:cNvSpPr/>
            <p:nvPr/>
          </p:nvSpPr>
          <p:spPr>
            <a:xfrm>
              <a:off x="1008000" y="4741920"/>
              <a:ext cx="48592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5" name="TextBox 26"/>
            <p:cNvSpPr/>
            <p:nvPr/>
          </p:nvSpPr>
          <p:spPr>
            <a:xfrm>
              <a:off x="1035720" y="4925160"/>
              <a:ext cx="5238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5760"/>
                  <a:tab algn="l" pos="911160"/>
                  <a:tab algn="l" pos="1366920"/>
                  <a:tab algn="l" pos="1822320"/>
                  <a:tab algn="l" pos="2278080"/>
                  <a:tab algn="l" pos="2733840"/>
                  <a:tab algn="l" pos="3189240"/>
                  <a:tab algn="l" pos="3645000"/>
                  <a:tab algn="l" pos="4100400"/>
                  <a:tab algn="l" pos="4556160"/>
                  <a:tab algn="l" pos="5011560"/>
                  <a:tab algn="l" pos="5467320"/>
                  <a:tab algn="l" pos="5923080"/>
                  <a:tab algn="l" pos="6378480"/>
                  <a:tab algn="l" pos="6834240"/>
                  <a:tab algn="l" pos="7289640"/>
                  <a:tab algn="l" pos="7745400"/>
                  <a:tab algn="l" pos="8201160"/>
                  <a:tab algn="l" pos="8656560"/>
                  <a:tab algn="l" pos="911232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70 dpi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6" name="TextBox 26"/>
            <p:cNvSpPr/>
            <p:nvPr/>
          </p:nvSpPr>
          <p:spPr>
            <a:xfrm>
              <a:off x="2013840" y="4925160"/>
              <a:ext cx="5238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5760"/>
                  <a:tab algn="l" pos="911160"/>
                  <a:tab algn="l" pos="1366920"/>
                  <a:tab algn="l" pos="1822320"/>
                  <a:tab algn="l" pos="2278080"/>
                  <a:tab algn="l" pos="2733840"/>
                  <a:tab algn="l" pos="3189240"/>
                  <a:tab algn="l" pos="3645000"/>
                  <a:tab algn="l" pos="4100400"/>
                  <a:tab algn="l" pos="4556160"/>
                  <a:tab algn="l" pos="5011560"/>
                  <a:tab algn="l" pos="5467320"/>
                  <a:tab algn="l" pos="5923080"/>
                  <a:tab algn="l" pos="6378480"/>
                  <a:tab algn="l" pos="6834240"/>
                  <a:tab algn="l" pos="7289640"/>
                  <a:tab algn="l" pos="7745400"/>
                  <a:tab algn="l" pos="8201160"/>
                  <a:tab algn="l" pos="8656560"/>
                  <a:tab algn="l" pos="911232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90 dpi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7" name="TextBox 26"/>
            <p:cNvSpPr/>
            <p:nvPr/>
          </p:nvSpPr>
          <p:spPr>
            <a:xfrm>
              <a:off x="2961360" y="4925160"/>
              <a:ext cx="5936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5760"/>
                  <a:tab algn="l" pos="911160"/>
                  <a:tab algn="l" pos="1366920"/>
                  <a:tab algn="l" pos="1822320"/>
                  <a:tab algn="l" pos="2278080"/>
                  <a:tab algn="l" pos="2733840"/>
                  <a:tab algn="l" pos="3189240"/>
                  <a:tab algn="l" pos="3645000"/>
                  <a:tab algn="l" pos="4100400"/>
                  <a:tab algn="l" pos="4556160"/>
                  <a:tab algn="l" pos="5011560"/>
                  <a:tab algn="l" pos="5467320"/>
                  <a:tab algn="l" pos="5923080"/>
                  <a:tab algn="l" pos="6378480"/>
                  <a:tab algn="l" pos="6834240"/>
                  <a:tab algn="l" pos="7289640"/>
                  <a:tab algn="l" pos="7745400"/>
                  <a:tab algn="l" pos="8201160"/>
                  <a:tab algn="l" pos="8656560"/>
                  <a:tab algn="l" pos="911232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110 dpi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8" name="TextBox 26"/>
            <p:cNvSpPr/>
            <p:nvPr/>
          </p:nvSpPr>
          <p:spPr>
            <a:xfrm>
              <a:off x="3944880" y="4925160"/>
              <a:ext cx="5936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5760"/>
                  <a:tab algn="l" pos="911160"/>
                  <a:tab algn="l" pos="1366920"/>
                  <a:tab algn="l" pos="1822320"/>
                  <a:tab algn="l" pos="2278080"/>
                  <a:tab algn="l" pos="2733840"/>
                  <a:tab algn="l" pos="3189240"/>
                  <a:tab algn="l" pos="3645000"/>
                  <a:tab algn="l" pos="4100400"/>
                  <a:tab algn="l" pos="4556160"/>
                  <a:tab algn="l" pos="5011560"/>
                  <a:tab algn="l" pos="5467320"/>
                  <a:tab algn="l" pos="5923080"/>
                  <a:tab algn="l" pos="6378480"/>
                  <a:tab algn="l" pos="6834240"/>
                  <a:tab algn="l" pos="7289640"/>
                  <a:tab algn="l" pos="7745400"/>
                  <a:tab algn="l" pos="8201160"/>
                  <a:tab algn="l" pos="8656560"/>
                  <a:tab algn="l" pos="911232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130 dpi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9" name="TextBox 26"/>
            <p:cNvSpPr/>
            <p:nvPr/>
          </p:nvSpPr>
          <p:spPr>
            <a:xfrm>
              <a:off x="4888080" y="4924440"/>
              <a:ext cx="6714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5760"/>
                  <a:tab algn="l" pos="911160"/>
                  <a:tab algn="l" pos="1366920"/>
                  <a:tab algn="l" pos="1822320"/>
                  <a:tab algn="l" pos="2278080"/>
                  <a:tab algn="l" pos="2733840"/>
                  <a:tab algn="l" pos="3189240"/>
                  <a:tab algn="l" pos="3645000"/>
                  <a:tab algn="l" pos="4100400"/>
                  <a:tab algn="l" pos="4556160"/>
                  <a:tab algn="l" pos="5011560"/>
                  <a:tab algn="l" pos="5467320"/>
                  <a:tab algn="l" pos="5923080"/>
                  <a:tab algn="l" pos="6378480"/>
                  <a:tab algn="l" pos="6834240"/>
                  <a:tab algn="l" pos="7289640"/>
                  <a:tab algn="l" pos="7745400"/>
                  <a:tab algn="l" pos="8201160"/>
                  <a:tab algn="l" pos="8656560"/>
                  <a:tab algn="l" pos="911232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Terminal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150" name="Picture 19" descr=""/>
            <p:cNvPicPr/>
            <p:nvPr/>
          </p:nvPicPr>
          <p:blipFill>
            <a:blip r:embed="rId11"/>
            <a:srcRect l="0" t="0" r="0" b="10155"/>
            <a:stretch/>
          </p:blipFill>
          <p:spPr>
            <a:xfrm>
              <a:off x="2878200" y="5146920"/>
              <a:ext cx="1044000" cy="14418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51" name="Picture 21" descr=""/>
            <p:cNvPicPr/>
            <p:nvPr/>
          </p:nvPicPr>
          <p:blipFill>
            <a:blip r:embed="rId12"/>
            <a:srcRect l="0" t="0" r="0" b="10076"/>
            <a:stretch/>
          </p:blipFill>
          <p:spPr>
            <a:xfrm>
              <a:off x="3859200" y="5146920"/>
              <a:ext cx="1044000" cy="14454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52" name="Picture 3" descr=""/>
            <p:cNvPicPr/>
            <p:nvPr/>
          </p:nvPicPr>
          <p:blipFill>
            <a:blip r:embed="rId13"/>
            <a:srcRect l="0" t="0" r="0" b="10092"/>
            <a:stretch/>
          </p:blipFill>
          <p:spPr>
            <a:xfrm>
              <a:off x="916200" y="5146920"/>
              <a:ext cx="1044000" cy="14454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53" name="Picture 4" descr=""/>
            <p:cNvPicPr/>
            <p:nvPr/>
          </p:nvPicPr>
          <p:blipFill>
            <a:blip r:embed="rId14"/>
            <a:srcRect l="0" t="0" r="0" b="10321"/>
            <a:stretch/>
          </p:blipFill>
          <p:spPr>
            <a:xfrm>
              <a:off x="1897200" y="5146920"/>
              <a:ext cx="1044000" cy="14418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54" name="Picture 5" descr=""/>
            <p:cNvPicPr/>
            <p:nvPr/>
          </p:nvPicPr>
          <p:blipFill>
            <a:blip r:embed="rId15"/>
            <a:srcRect l="0" t="0" r="0" b="10550"/>
            <a:stretch/>
          </p:blipFill>
          <p:spPr>
            <a:xfrm>
              <a:off x="4840200" y="5146920"/>
              <a:ext cx="1044000" cy="14378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55" name="TextBox 26"/>
            <p:cNvSpPr/>
            <p:nvPr/>
          </p:nvSpPr>
          <p:spPr>
            <a:xfrm>
              <a:off x="3062880" y="6634800"/>
              <a:ext cx="7491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5760"/>
                  <a:tab algn="l" pos="911160"/>
                  <a:tab algn="l" pos="1366920"/>
                  <a:tab algn="l" pos="1822320"/>
                  <a:tab algn="l" pos="2278080"/>
                  <a:tab algn="l" pos="2733840"/>
                  <a:tab algn="l" pos="3189240"/>
                  <a:tab algn="l" pos="3645000"/>
                  <a:tab algn="l" pos="4100400"/>
                  <a:tab algn="l" pos="4556160"/>
                  <a:tab algn="l" pos="5011560"/>
                  <a:tab algn="l" pos="5467320"/>
                  <a:tab algn="l" pos="5923080"/>
                  <a:tab algn="l" pos="6378480"/>
                  <a:tab algn="l" pos="6834240"/>
                  <a:tab algn="l" pos="7289640"/>
                  <a:tab algn="l" pos="7745400"/>
                  <a:tab algn="l" pos="8201160"/>
                  <a:tab algn="l" pos="8656560"/>
                  <a:tab algn="l" pos="911232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Cortical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6" name="Straight Connector 130"/>
            <p:cNvSpPr/>
            <p:nvPr/>
          </p:nvSpPr>
          <p:spPr>
            <a:xfrm>
              <a:off x="1008000" y="6643800"/>
              <a:ext cx="45720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7" name="TextBox 26"/>
            <p:cNvSpPr/>
            <p:nvPr/>
          </p:nvSpPr>
          <p:spPr>
            <a:xfrm>
              <a:off x="1035720" y="6844680"/>
              <a:ext cx="5238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5760"/>
                  <a:tab algn="l" pos="911160"/>
                  <a:tab algn="l" pos="1366920"/>
                  <a:tab algn="l" pos="1822320"/>
                  <a:tab algn="l" pos="2278080"/>
                  <a:tab algn="l" pos="2733840"/>
                  <a:tab algn="l" pos="3189240"/>
                  <a:tab algn="l" pos="3645000"/>
                  <a:tab algn="l" pos="4100400"/>
                  <a:tab algn="l" pos="4556160"/>
                  <a:tab algn="l" pos="5011560"/>
                  <a:tab algn="l" pos="5467320"/>
                  <a:tab algn="l" pos="5923080"/>
                  <a:tab algn="l" pos="6378480"/>
                  <a:tab algn="l" pos="6834240"/>
                  <a:tab algn="l" pos="7289640"/>
                  <a:tab algn="l" pos="7745400"/>
                  <a:tab algn="l" pos="8201160"/>
                  <a:tab algn="l" pos="8656560"/>
                  <a:tab algn="l" pos="911232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70 dpi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8" name="TextBox 26"/>
            <p:cNvSpPr/>
            <p:nvPr/>
          </p:nvSpPr>
          <p:spPr>
            <a:xfrm>
              <a:off x="2013840" y="6844680"/>
              <a:ext cx="5238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5760"/>
                  <a:tab algn="l" pos="911160"/>
                  <a:tab algn="l" pos="1366920"/>
                  <a:tab algn="l" pos="1822320"/>
                  <a:tab algn="l" pos="2278080"/>
                  <a:tab algn="l" pos="2733840"/>
                  <a:tab algn="l" pos="3189240"/>
                  <a:tab algn="l" pos="3645000"/>
                  <a:tab algn="l" pos="4100400"/>
                  <a:tab algn="l" pos="4556160"/>
                  <a:tab algn="l" pos="5011560"/>
                  <a:tab algn="l" pos="5467320"/>
                  <a:tab algn="l" pos="5923080"/>
                  <a:tab algn="l" pos="6378480"/>
                  <a:tab algn="l" pos="6834240"/>
                  <a:tab algn="l" pos="7289640"/>
                  <a:tab algn="l" pos="7745400"/>
                  <a:tab algn="l" pos="8201160"/>
                  <a:tab algn="l" pos="8656560"/>
                  <a:tab algn="l" pos="911232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90 dpi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9" name="TextBox 26"/>
            <p:cNvSpPr/>
            <p:nvPr/>
          </p:nvSpPr>
          <p:spPr>
            <a:xfrm>
              <a:off x="2961360" y="6844680"/>
              <a:ext cx="5936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5760"/>
                  <a:tab algn="l" pos="911160"/>
                  <a:tab algn="l" pos="1366920"/>
                  <a:tab algn="l" pos="1822320"/>
                  <a:tab algn="l" pos="2278080"/>
                  <a:tab algn="l" pos="2733840"/>
                  <a:tab algn="l" pos="3189240"/>
                  <a:tab algn="l" pos="3645000"/>
                  <a:tab algn="l" pos="4100400"/>
                  <a:tab algn="l" pos="4556160"/>
                  <a:tab algn="l" pos="5011560"/>
                  <a:tab algn="l" pos="5467320"/>
                  <a:tab algn="l" pos="5923080"/>
                  <a:tab algn="l" pos="6378480"/>
                  <a:tab algn="l" pos="6834240"/>
                  <a:tab algn="l" pos="7289640"/>
                  <a:tab algn="l" pos="7745400"/>
                  <a:tab algn="l" pos="8201160"/>
                  <a:tab algn="l" pos="8656560"/>
                  <a:tab algn="l" pos="911232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110 dpi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0" name="TextBox 26"/>
            <p:cNvSpPr/>
            <p:nvPr/>
          </p:nvSpPr>
          <p:spPr>
            <a:xfrm>
              <a:off x="3944880" y="6844680"/>
              <a:ext cx="5936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5760"/>
                  <a:tab algn="l" pos="911160"/>
                  <a:tab algn="l" pos="1366920"/>
                  <a:tab algn="l" pos="1822320"/>
                  <a:tab algn="l" pos="2278080"/>
                  <a:tab algn="l" pos="2733840"/>
                  <a:tab algn="l" pos="3189240"/>
                  <a:tab algn="l" pos="3645000"/>
                  <a:tab algn="l" pos="4100400"/>
                  <a:tab algn="l" pos="4556160"/>
                  <a:tab algn="l" pos="5011560"/>
                  <a:tab algn="l" pos="5467320"/>
                  <a:tab algn="l" pos="5923080"/>
                  <a:tab algn="l" pos="6378480"/>
                  <a:tab algn="l" pos="6834240"/>
                  <a:tab algn="l" pos="7289640"/>
                  <a:tab algn="l" pos="7745400"/>
                  <a:tab algn="l" pos="8201160"/>
                  <a:tab algn="l" pos="8656560"/>
                  <a:tab algn="l" pos="911232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130 dpi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1" name="TextBox 26"/>
            <p:cNvSpPr/>
            <p:nvPr/>
          </p:nvSpPr>
          <p:spPr>
            <a:xfrm>
              <a:off x="4888080" y="6843960"/>
              <a:ext cx="6714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5760"/>
                  <a:tab algn="l" pos="911160"/>
                  <a:tab algn="l" pos="1366920"/>
                  <a:tab algn="l" pos="1822320"/>
                  <a:tab algn="l" pos="2278080"/>
                  <a:tab algn="l" pos="2733840"/>
                  <a:tab algn="l" pos="3189240"/>
                  <a:tab algn="l" pos="3645000"/>
                  <a:tab algn="l" pos="4100400"/>
                  <a:tab algn="l" pos="4556160"/>
                  <a:tab algn="l" pos="5011560"/>
                  <a:tab algn="l" pos="5467320"/>
                  <a:tab algn="l" pos="5923080"/>
                  <a:tab algn="l" pos="6378480"/>
                  <a:tab algn="l" pos="6834240"/>
                  <a:tab algn="l" pos="7289640"/>
                  <a:tab algn="l" pos="7745400"/>
                  <a:tab algn="l" pos="8201160"/>
                  <a:tab algn="l" pos="8656560"/>
                  <a:tab algn="l" pos="911232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Terminal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162" name="Picture 23" descr=""/>
            <p:cNvPicPr/>
            <p:nvPr/>
          </p:nvPicPr>
          <p:blipFill>
            <a:blip r:embed="rId16"/>
            <a:srcRect l="0" t="0" r="0" b="10178"/>
            <a:stretch/>
          </p:blipFill>
          <p:spPr>
            <a:xfrm>
              <a:off x="916200" y="7073280"/>
              <a:ext cx="1044000" cy="14432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63" name="Picture 24" descr=""/>
            <p:cNvPicPr/>
            <p:nvPr/>
          </p:nvPicPr>
          <p:blipFill>
            <a:blip r:embed="rId17"/>
            <a:srcRect l="0" t="0" r="0" b="10178"/>
            <a:stretch/>
          </p:blipFill>
          <p:spPr>
            <a:xfrm>
              <a:off x="1897200" y="7073280"/>
              <a:ext cx="1044000" cy="14432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64" name="Picture 25" descr=""/>
            <p:cNvPicPr/>
            <p:nvPr/>
          </p:nvPicPr>
          <p:blipFill>
            <a:blip r:embed="rId18"/>
            <a:srcRect l="0" t="0" r="0" b="10486"/>
            <a:stretch/>
          </p:blipFill>
          <p:spPr>
            <a:xfrm>
              <a:off x="2878200" y="7073280"/>
              <a:ext cx="1044000" cy="14360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65" name="Picture 26" descr=""/>
            <p:cNvPicPr/>
            <p:nvPr/>
          </p:nvPicPr>
          <p:blipFill>
            <a:blip r:embed="rId19"/>
            <a:srcRect l="0" t="0" r="0" b="10636"/>
            <a:stretch/>
          </p:blipFill>
          <p:spPr>
            <a:xfrm>
              <a:off x="3859200" y="7073280"/>
              <a:ext cx="1044000" cy="14360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66" name="Picture 7" descr=""/>
            <p:cNvPicPr/>
            <p:nvPr/>
          </p:nvPicPr>
          <p:blipFill>
            <a:blip r:embed="rId20"/>
            <a:srcRect l="0" t="0" r="0" b="10652"/>
            <a:stretch/>
          </p:blipFill>
          <p:spPr>
            <a:xfrm>
              <a:off x="4840200" y="7073280"/>
              <a:ext cx="1044000" cy="14360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67" name="TextBox 7"/>
            <p:cNvSpPr/>
            <p:nvPr/>
          </p:nvSpPr>
          <p:spPr>
            <a:xfrm>
              <a:off x="934920" y="4482360"/>
              <a:ext cx="3589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5760"/>
                  <a:tab algn="l" pos="911160"/>
                  <a:tab algn="l" pos="1366920"/>
                  <a:tab algn="l" pos="1822320"/>
                  <a:tab algn="l" pos="2278080"/>
                  <a:tab algn="l" pos="2733840"/>
                  <a:tab algn="l" pos="3189240"/>
                  <a:tab algn="l" pos="3645000"/>
                  <a:tab algn="l" pos="4100400"/>
                  <a:tab algn="l" pos="4556160"/>
                  <a:tab algn="l" pos="5011560"/>
                  <a:tab algn="l" pos="5467320"/>
                  <a:tab algn="l" pos="5923080"/>
                  <a:tab algn="l" pos="6378480"/>
                  <a:tab algn="l" pos="6834240"/>
                  <a:tab algn="l" pos="7289640"/>
                  <a:tab algn="l" pos="7745400"/>
                  <a:tab algn="l" pos="8201160"/>
                  <a:tab algn="l" pos="8656560"/>
                  <a:tab algn="l" pos="911232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B.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8" name="TextBox 7"/>
            <p:cNvSpPr/>
            <p:nvPr/>
          </p:nvSpPr>
          <p:spPr>
            <a:xfrm>
              <a:off x="934560" y="87480"/>
              <a:ext cx="3589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5760"/>
                  <a:tab algn="l" pos="911160"/>
                  <a:tab algn="l" pos="1366920"/>
                  <a:tab algn="l" pos="1822320"/>
                  <a:tab algn="l" pos="2278080"/>
                  <a:tab algn="l" pos="2733840"/>
                  <a:tab algn="l" pos="3189240"/>
                  <a:tab algn="l" pos="3645000"/>
                  <a:tab algn="l" pos="4100400"/>
                  <a:tab algn="l" pos="4556160"/>
                  <a:tab algn="l" pos="5011560"/>
                  <a:tab algn="l" pos="5467320"/>
                  <a:tab algn="l" pos="5923080"/>
                  <a:tab algn="l" pos="6378480"/>
                  <a:tab algn="l" pos="6834240"/>
                  <a:tab algn="l" pos="7289640"/>
                  <a:tab algn="l" pos="7745400"/>
                  <a:tab algn="l" pos="8201160"/>
                  <a:tab algn="l" pos="8656560"/>
                  <a:tab algn="l" pos="911232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A.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9" name="Rectangle 100"/>
            <p:cNvSpPr/>
            <p:nvPr/>
          </p:nvSpPr>
          <p:spPr>
            <a:xfrm>
              <a:off x="256680" y="8705160"/>
              <a:ext cx="16754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5760"/>
                  <a:tab algn="l" pos="911160"/>
                  <a:tab algn="l" pos="1366920"/>
                  <a:tab algn="l" pos="1822320"/>
                  <a:tab algn="l" pos="2278080"/>
                  <a:tab algn="l" pos="2733840"/>
                  <a:tab algn="l" pos="3189240"/>
                  <a:tab algn="l" pos="3645000"/>
                  <a:tab algn="l" pos="4100400"/>
                  <a:tab algn="l" pos="4556160"/>
                  <a:tab algn="l" pos="5011560"/>
                  <a:tab algn="l" pos="5467320"/>
                  <a:tab algn="l" pos="5923080"/>
                  <a:tab algn="l" pos="6378480"/>
                  <a:tab algn="l" pos="6834240"/>
                  <a:tab algn="l" pos="7289640"/>
                  <a:tab algn="l" pos="7745400"/>
                  <a:tab algn="l" pos="8201160"/>
                  <a:tab algn="l" pos="8656560"/>
                  <a:tab algn="l" pos="911232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Expression/Phosphorylation Level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grpSp>
          <p:nvGrpSpPr>
            <p:cNvPr id="170" name="Group 1"/>
            <p:cNvGrpSpPr/>
            <p:nvPr/>
          </p:nvGrpSpPr>
          <p:grpSpPr>
            <a:xfrm>
              <a:off x="250920" y="8872920"/>
              <a:ext cx="6348240" cy="215640"/>
              <a:chOff x="250920" y="8872920"/>
              <a:chExt cx="6348240" cy="215640"/>
            </a:xfrm>
          </p:grpSpPr>
          <p:grpSp>
            <p:nvGrpSpPr>
              <p:cNvPr id="171" name="Group 102"/>
              <p:cNvGrpSpPr/>
              <p:nvPr/>
            </p:nvGrpSpPr>
            <p:grpSpPr>
              <a:xfrm>
                <a:off x="2437920" y="8872920"/>
                <a:ext cx="753480" cy="215640"/>
                <a:chOff x="2437920" y="8872920"/>
                <a:chExt cx="753480" cy="215640"/>
              </a:xfrm>
            </p:grpSpPr>
            <p:sp>
              <p:nvSpPr>
                <p:cNvPr id="172" name="Rectangle 103"/>
                <p:cNvSpPr/>
                <p:nvPr/>
              </p:nvSpPr>
              <p:spPr>
                <a:xfrm>
                  <a:off x="2580840" y="8872920"/>
                  <a:ext cx="61056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5760"/>
                      <a:tab algn="l" pos="911160"/>
                      <a:tab algn="l" pos="1366920"/>
                      <a:tab algn="l" pos="1822320"/>
                      <a:tab algn="l" pos="2278080"/>
                      <a:tab algn="l" pos="2733840"/>
                      <a:tab algn="l" pos="3189240"/>
                      <a:tab algn="l" pos="3645000"/>
                      <a:tab algn="l" pos="4100400"/>
                      <a:tab algn="l" pos="4556160"/>
                      <a:tab algn="l" pos="5011560"/>
                      <a:tab algn="l" pos="5467320"/>
                      <a:tab algn="l" pos="5923080"/>
                      <a:tab algn="l" pos="6378480"/>
                      <a:tab algn="l" pos="6834240"/>
                      <a:tab algn="l" pos="7289640"/>
                      <a:tab algn="l" pos="7745400"/>
                      <a:tab algn="l" pos="8201160"/>
                      <a:tab algn="l" pos="8656560"/>
                      <a:tab algn="l" pos="9112320"/>
                    </a:tabLst>
                  </a:pPr>
                  <a:r>
                    <a:rPr b="0" lang="en-US" sz="8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0.91-1.10</a:t>
                  </a:r>
                  <a:endParaRPr b="0" lang="en-US" sz="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73" name="Rounded Rectangle 148"/>
                <p:cNvSpPr/>
                <p:nvPr/>
              </p:nvSpPr>
              <p:spPr>
                <a:xfrm>
                  <a:off x="2437920" y="8928360"/>
                  <a:ext cx="182520" cy="109080"/>
                </a:xfrm>
                <a:prstGeom prst="roundRect">
                  <a:avLst>
                    <a:gd name="adj" fmla="val 16667"/>
                  </a:avLst>
                </a:prstGeom>
                <a:solidFill>
                  <a:srgbClr val="ffff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54720" rIns="54720" tIns="45000" bIns="45000" anchor="ctr">
                  <a:noAutofit/>
                </a:bodyPr>
                <a:p>
                  <a:pPr algn="ctr">
                    <a:lnSpc>
                      <a:spcPct val="9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  <p:grpSp>
            <p:nvGrpSpPr>
              <p:cNvPr id="174" name="Group 108"/>
              <p:cNvGrpSpPr/>
              <p:nvPr/>
            </p:nvGrpSpPr>
            <p:grpSpPr>
              <a:xfrm>
                <a:off x="864360" y="8872920"/>
                <a:ext cx="753480" cy="215640"/>
                <a:chOff x="864360" y="8872920"/>
                <a:chExt cx="753480" cy="215640"/>
              </a:xfrm>
            </p:grpSpPr>
            <p:sp>
              <p:nvSpPr>
                <p:cNvPr id="175" name="Rectangle 109"/>
                <p:cNvSpPr/>
                <p:nvPr/>
              </p:nvSpPr>
              <p:spPr>
                <a:xfrm>
                  <a:off x="1007280" y="8872920"/>
                  <a:ext cx="61056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5760"/>
                      <a:tab algn="l" pos="911160"/>
                      <a:tab algn="l" pos="1366920"/>
                      <a:tab algn="l" pos="1822320"/>
                      <a:tab algn="l" pos="2278080"/>
                      <a:tab algn="l" pos="2733840"/>
                      <a:tab algn="l" pos="3189240"/>
                      <a:tab algn="l" pos="3645000"/>
                      <a:tab algn="l" pos="4100400"/>
                      <a:tab algn="l" pos="4556160"/>
                      <a:tab algn="l" pos="5011560"/>
                      <a:tab algn="l" pos="5467320"/>
                      <a:tab algn="l" pos="5923080"/>
                      <a:tab algn="l" pos="6378480"/>
                      <a:tab algn="l" pos="6834240"/>
                      <a:tab algn="l" pos="7289640"/>
                      <a:tab algn="l" pos="7745400"/>
                      <a:tab algn="l" pos="8201160"/>
                      <a:tab algn="l" pos="8656560"/>
                      <a:tab algn="l" pos="9112320"/>
                    </a:tabLst>
                  </a:pPr>
                  <a:r>
                    <a:rPr b="0" lang="en-US" sz="8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1.31-1.50</a:t>
                  </a:r>
                  <a:endParaRPr b="0" lang="en-US" sz="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76" name="Rounded Rectangle 148"/>
                <p:cNvSpPr/>
                <p:nvPr/>
              </p:nvSpPr>
              <p:spPr>
                <a:xfrm>
                  <a:off x="864360" y="8928360"/>
                  <a:ext cx="182520" cy="109080"/>
                </a:xfrm>
                <a:prstGeom prst="roundRect">
                  <a:avLst>
                    <a:gd name="adj" fmla="val 16667"/>
                  </a:avLst>
                </a:prstGeom>
                <a:solidFill>
                  <a:srgbClr val="fa2606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54720" rIns="54720" tIns="45000" bIns="45000" anchor="ctr">
                  <a:noAutofit/>
                </a:bodyPr>
                <a:p>
                  <a:pPr algn="ctr">
                    <a:lnSpc>
                      <a:spcPct val="9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  <p:grpSp>
            <p:nvGrpSpPr>
              <p:cNvPr id="177" name="Group 111"/>
              <p:cNvGrpSpPr/>
              <p:nvPr/>
            </p:nvGrpSpPr>
            <p:grpSpPr>
              <a:xfrm>
                <a:off x="4777200" y="8872920"/>
                <a:ext cx="753480" cy="215640"/>
                <a:chOff x="4777200" y="8872920"/>
                <a:chExt cx="753480" cy="215640"/>
              </a:xfrm>
            </p:grpSpPr>
            <p:sp>
              <p:nvSpPr>
                <p:cNvPr id="178" name="Rectangle 112"/>
                <p:cNvSpPr/>
                <p:nvPr/>
              </p:nvSpPr>
              <p:spPr>
                <a:xfrm>
                  <a:off x="4920120" y="8872920"/>
                  <a:ext cx="61056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5760"/>
                      <a:tab algn="l" pos="911160"/>
                      <a:tab algn="l" pos="1366920"/>
                      <a:tab algn="l" pos="1822320"/>
                      <a:tab algn="l" pos="2278080"/>
                      <a:tab algn="l" pos="2733840"/>
                      <a:tab algn="l" pos="3189240"/>
                      <a:tab algn="l" pos="3645000"/>
                      <a:tab algn="l" pos="4100400"/>
                      <a:tab algn="l" pos="4556160"/>
                      <a:tab algn="l" pos="5011560"/>
                      <a:tab algn="l" pos="5467320"/>
                      <a:tab algn="l" pos="5923080"/>
                      <a:tab algn="l" pos="6378480"/>
                      <a:tab algn="l" pos="6834240"/>
                      <a:tab algn="l" pos="7289640"/>
                      <a:tab algn="l" pos="7745400"/>
                      <a:tab algn="l" pos="8201160"/>
                      <a:tab algn="l" pos="8656560"/>
                      <a:tab algn="l" pos="9112320"/>
                    </a:tabLst>
                  </a:pPr>
                  <a:r>
                    <a:rPr b="0" lang="en-US" sz="8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0.01-0.50</a:t>
                  </a:r>
                  <a:endParaRPr b="0" lang="en-US" sz="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79" name="Rounded Rectangle 148"/>
                <p:cNvSpPr/>
                <p:nvPr/>
              </p:nvSpPr>
              <p:spPr>
                <a:xfrm>
                  <a:off x="4777200" y="8931240"/>
                  <a:ext cx="182520" cy="109080"/>
                </a:xfrm>
                <a:prstGeom prst="roundRect">
                  <a:avLst>
                    <a:gd name="adj" fmla="val 16667"/>
                  </a:avLst>
                </a:prstGeom>
                <a:solidFill>
                  <a:srgbClr val="003b06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54720" rIns="54720" tIns="45000" bIns="45000" anchor="ctr">
                  <a:noAutofit/>
                </a:bodyPr>
                <a:p>
                  <a:pPr algn="ctr">
                    <a:lnSpc>
                      <a:spcPct val="9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  <p:grpSp>
            <p:nvGrpSpPr>
              <p:cNvPr id="180" name="Group 118"/>
              <p:cNvGrpSpPr/>
              <p:nvPr/>
            </p:nvGrpSpPr>
            <p:grpSpPr>
              <a:xfrm>
                <a:off x="1657440" y="8872920"/>
                <a:ext cx="749880" cy="215640"/>
                <a:chOff x="1657440" y="8872920"/>
                <a:chExt cx="749880" cy="215640"/>
              </a:xfrm>
            </p:grpSpPr>
            <p:sp>
              <p:nvSpPr>
                <p:cNvPr id="181" name="Rectangle 119"/>
                <p:cNvSpPr/>
                <p:nvPr/>
              </p:nvSpPr>
              <p:spPr>
                <a:xfrm>
                  <a:off x="1796760" y="8872920"/>
                  <a:ext cx="61056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5760"/>
                      <a:tab algn="l" pos="911160"/>
                      <a:tab algn="l" pos="1366920"/>
                      <a:tab algn="l" pos="1822320"/>
                      <a:tab algn="l" pos="2278080"/>
                      <a:tab algn="l" pos="2733840"/>
                      <a:tab algn="l" pos="3189240"/>
                      <a:tab algn="l" pos="3645000"/>
                      <a:tab algn="l" pos="4100400"/>
                      <a:tab algn="l" pos="4556160"/>
                      <a:tab algn="l" pos="5011560"/>
                      <a:tab algn="l" pos="5467320"/>
                      <a:tab algn="l" pos="5923080"/>
                      <a:tab algn="l" pos="6378480"/>
                      <a:tab algn="l" pos="6834240"/>
                      <a:tab algn="l" pos="7289640"/>
                      <a:tab algn="l" pos="7745400"/>
                      <a:tab algn="l" pos="8201160"/>
                      <a:tab algn="l" pos="8656560"/>
                      <a:tab algn="l" pos="9112320"/>
                    </a:tabLst>
                  </a:pPr>
                  <a:r>
                    <a:rPr b="0" lang="en-US" sz="8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1.11-1.30</a:t>
                  </a:r>
                  <a:endParaRPr b="0" lang="en-US" sz="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82" name="Rounded Rectangle 148"/>
                <p:cNvSpPr/>
                <p:nvPr/>
              </p:nvSpPr>
              <p:spPr>
                <a:xfrm>
                  <a:off x="1657440" y="8928000"/>
                  <a:ext cx="182160" cy="109080"/>
                </a:xfrm>
                <a:prstGeom prst="roundRect">
                  <a:avLst>
                    <a:gd name="adj" fmla="val 16667"/>
                  </a:avLst>
                </a:prstGeom>
                <a:solidFill>
                  <a:srgbClr val="ffa102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54720" rIns="54720" tIns="45000" bIns="45000" anchor="ctr">
                  <a:noAutofit/>
                </a:bodyPr>
                <a:p>
                  <a:pPr algn="ctr">
                    <a:lnSpc>
                      <a:spcPct val="9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  <p:grpSp>
            <p:nvGrpSpPr>
              <p:cNvPr id="183" name="Group 114"/>
              <p:cNvGrpSpPr/>
              <p:nvPr/>
            </p:nvGrpSpPr>
            <p:grpSpPr>
              <a:xfrm>
                <a:off x="3215520" y="8872920"/>
                <a:ext cx="753480" cy="215640"/>
                <a:chOff x="3215520" y="8872920"/>
                <a:chExt cx="753480" cy="215640"/>
              </a:xfrm>
            </p:grpSpPr>
            <p:sp>
              <p:nvSpPr>
                <p:cNvPr id="184" name="Rectangle 122"/>
                <p:cNvSpPr/>
                <p:nvPr/>
              </p:nvSpPr>
              <p:spPr>
                <a:xfrm>
                  <a:off x="3358440" y="8872920"/>
                  <a:ext cx="61056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5760"/>
                      <a:tab algn="l" pos="911160"/>
                      <a:tab algn="l" pos="1366920"/>
                      <a:tab algn="l" pos="1822320"/>
                      <a:tab algn="l" pos="2278080"/>
                      <a:tab algn="l" pos="2733840"/>
                      <a:tab algn="l" pos="3189240"/>
                      <a:tab algn="l" pos="3645000"/>
                      <a:tab algn="l" pos="4100400"/>
                      <a:tab algn="l" pos="4556160"/>
                      <a:tab algn="l" pos="5011560"/>
                      <a:tab algn="l" pos="5467320"/>
                      <a:tab algn="l" pos="5923080"/>
                      <a:tab algn="l" pos="6378480"/>
                      <a:tab algn="l" pos="6834240"/>
                      <a:tab algn="l" pos="7289640"/>
                      <a:tab algn="l" pos="7745400"/>
                      <a:tab algn="l" pos="8201160"/>
                      <a:tab algn="l" pos="8656560"/>
                      <a:tab algn="l" pos="9112320"/>
                    </a:tabLst>
                  </a:pPr>
                  <a:r>
                    <a:rPr b="0" lang="en-US" sz="8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0.71-0.90</a:t>
                  </a:r>
                  <a:endParaRPr b="0" lang="en-US" sz="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85" name="Rounded Rectangle 148"/>
                <p:cNvSpPr/>
                <p:nvPr/>
              </p:nvSpPr>
              <p:spPr>
                <a:xfrm>
                  <a:off x="3215520" y="8931600"/>
                  <a:ext cx="182520" cy="109440"/>
                </a:xfrm>
                <a:prstGeom prst="roundRect">
                  <a:avLst>
                    <a:gd name="adj" fmla="val 16667"/>
                  </a:avLst>
                </a:prstGeom>
                <a:solidFill>
                  <a:srgbClr val="84ff02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54720" rIns="54720" tIns="45360" bIns="45360" anchor="ctr">
                  <a:noAutofit/>
                </a:bodyPr>
                <a:p>
                  <a:pPr algn="ctr">
                    <a:lnSpc>
                      <a:spcPct val="9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  <p:grpSp>
            <p:nvGrpSpPr>
              <p:cNvPr id="186" name="Group 128"/>
              <p:cNvGrpSpPr/>
              <p:nvPr/>
            </p:nvGrpSpPr>
            <p:grpSpPr>
              <a:xfrm>
                <a:off x="250920" y="8872920"/>
                <a:ext cx="589680" cy="215640"/>
                <a:chOff x="250920" y="8872920"/>
                <a:chExt cx="589680" cy="215640"/>
              </a:xfrm>
            </p:grpSpPr>
            <p:sp>
              <p:nvSpPr>
                <p:cNvPr id="187" name="Rectangle 122"/>
                <p:cNvSpPr/>
                <p:nvPr/>
              </p:nvSpPr>
              <p:spPr>
                <a:xfrm>
                  <a:off x="381240" y="8872920"/>
                  <a:ext cx="45936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5760"/>
                      <a:tab algn="l" pos="911160"/>
                      <a:tab algn="l" pos="1366920"/>
                      <a:tab algn="l" pos="1822320"/>
                      <a:tab algn="l" pos="2278080"/>
                      <a:tab algn="l" pos="2733840"/>
                      <a:tab algn="l" pos="3189240"/>
                      <a:tab algn="l" pos="3645000"/>
                      <a:tab algn="l" pos="4100400"/>
                      <a:tab algn="l" pos="4556160"/>
                      <a:tab algn="l" pos="5011560"/>
                      <a:tab algn="l" pos="5467320"/>
                      <a:tab algn="l" pos="5923080"/>
                      <a:tab algn="l" pos="6378480"/>
                      <a:tab algn="l" pos="6834240"/>
                      <a:tab algn="l" pos="7289640"/>
                      <a:tab algn="l" pos="7745400"/>
                      <a:tab algn="l" pos="8201160"/>
                      <a:tab algn="l" pos="8656560"/>
                      <a:tab algn="l" pos="9112320"/>
                    </a:tabLst>
                  </a:pPr>
                  <a:r>
                    <a:rPr b="0" lang="en-US" sz="800" spc="-1" strike="noStrike">
                      <a:solidFill>
                        <a:srgbClr val="000000"/>
                      </a:solidFill>
                      <a:latin typeface="Symbol"/>
                      <a:ea typeface="Symbol"/>
                    </a:rPr>
                    <a:t></a:t>
                  </a:r>
                  <a:r>
                    <a:rPr b="0" lang="en-US" sz="8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1.51</a:t>
                  </a:r>
                  <a:endParaRPr b="0" lang="en-US" sz="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88" name="Rounded Rectangle 148"/>
                <p:cNvSpPr/>
                <p:nvPr/>
              </p:nvSpPr>
              <p:spPr>
                <a:xfrm>
                  <a:off x="250920" y="8926560"/>
                  <a:ext cx="182160" cy="109440"/>
                </a:xfrm>
                <a:prstGeom prst="roundRect">
                  <a:avLst>
                    <a:gd name="adj" fmla="val 16667"/>
                  </a:avLst>
                </a:prstGeom>
                <a:solidFill>
                  <a:srgbClr val="800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54720" rIns="54720" tIns="45360" bIns="45360" anchor="ctr">
                  <a:noAutofit/>
                </a:bodyPr>
                <a:p>
                  <a:pPr algn="ctr">
                    <a:lnSpc>
                      <a:spcPct val="9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  <p:grpSp>
            <p:nvGrpSpPr>
              <p:cNvPr id="189" name="Group 131"/>
              <p:cNvGrpSpPr/>
              <p:nvPr/>
            </p:nvGrpSpPr>
            <p:grpSpPr>
              <a:xfrm>
                <a:off x="3996360" y="8872920"/>
                <a:ext cx="753480" cy="215640"/>
                <a:chOff x="3996360" y="8872920"/>
                <a:chExt cx="753480" cy="215640"/>
              </a:xfrm>
            </p:grpSpPr>
            <p:sp>
              <p:nvSpPr>
                <p:cNvPr id="190" name="Rectangle 132"/>
                <p:cNvSpPr/>
                <p:nvPr/>
              </p:nvSpPr>
              <p:spPr>
                <a:xfrm>
                  <a:off x="4139280" y="8872920"/>
                  <a:ext cx="61056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5760"/>
                      <a:tab algn="l" pos="911160"/>
                      <a:tab algn="l" pos="1366920"/>
                      <a:tab algn="l" pos="1822320"/>
                      <a:tab algn="l" pos="2278080"/>
                      <a:tab algn="l" pos="2733840"/>
                      <a:tab algn="l" pos="3189240"/>
                      <a:tab algn="l" pos="3645000"/>
                      <a:tab algn="l" pos="4100400"/>
                      <a:tab algn="l" pos="4556160"/>
                      <a:tab algn="l" pos="5011560"/>
                      <a:tab algn="l" pos="5467320"/>
                      <a:tab algn="l" pos="5923080"/>
                      <a:tab algn="l" pos="6378480"/>
                      <a:tab algn="l" pos="6834240"/>
                      <a:tab algn="l" pos="7289640"/>
                      <a:tab algn="l" pos="7745400"/>
                      <a:tab algn="l" pos="8201160"/>
                      <a:tab algn="l" pos="8656560"/>
                      <a:tab algn="l" pos="9112320"/>
                    </a:tabLst>
                  </a:pPr>
                  <a:r>
                    <a:rPr b="0" lang="en-US" sz="8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0.51-0.70</a:t>
                  </a:r>
                  <a:endParaRPr b="0" lang="en-US" sz="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91" name="Rounded Rectangle 148"/>
                <p:cNvSpPr/>
                <p:nvPr/>
              </p:nvSpPr>
              <p:spPr>
                <a:xfrm>
                  <a:off x="3996360" y="8931600"/>
                  <a:ext cx="182520" cy="109440"/>
                </a:xfrm>
                <a:prstGeom prst="roundRect">
                  <a:avLst>
                    <a:gd name="adj" fmla="val 16667"/>
                  </a:avLst>
                </a:prstGeom>
                <a:solidFill>
                  <a:srgbClr val="009601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54720" rIns="54720" tIns="45360" bIns="45360" anchor="ctr">
                  <a:noAutofit/>
                </a:bodyPr>
                <a:p>
                  <a:pPr algn="ctr">
                    <a:lnSpc>
                      <a:spcPct val="9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  <p:grpSp>
            <p:nvGrpSpPr>
              <p:cNvPr id="192" name="Group 111"/>
              <p:cNvGrpSpPr/>
              <p:nvPr/>
            </p:nvGrpSpPr>
            <p:grpSpPr>
              <a:xfrm>
                <a:off x="5551560" y="8872920"/>
                <a:ext cx="1047600" cy="215640"/>
                <a:chOff x="5551560" y="8872920"/>
                <a:chExt cx="1047600" cy="215640"/>
              </a:xfrm>
            </p:grpSpPr>
            <p:sp>
              <p:nvSpPr>
                <p:cNvPr id="193" name="Rectangle 112"/>
                <p:cNvSpPr/>
                <p:nvPr/>
              </p:nvSpPr>
              <p:spPr>
                <a:xfrm>
                  <a:off x="5699160" y="8872920"/>
                  <a:ext cx="90000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5760"/>
                      <a:tab algn="l" pos="911160"/>
                      <a:tab algn="l" pos="1366920"/>
                      <a:tab algn="l" pos="1822320"/>
                      <a:tab algn="l" pos="2278080"/>
                      <a:tab algn="l" pos="2733840"/>
                      <a:tab algn="l" pos="3189240"/>
                      <a:tab algn="l" pos="3645000"/>
                      <a:tab algn="l" pos="4100400"/>
                      <a:tab algn="l" pos="4556160"/>
                      <a:tab algn="l" pos="5011560"/>
                      <a:tab algn="l" pos="5467320"/>
                      <a:tab algn="l" pos="5923080"/>
                      <a:tab algn="l" pos="6378480"/>
                      <a:tab algn="l" pos="6834240"/>
                      <a:tab algn="l" pos="7289640"/>
                      <a:tab algn="l" pos="7745400"/>
                      <a:tab algn="l" pos="8201160"/>
                      <a:tab algn="l" pos="8656560"/>
                      <a:tab algn="l" pos="9112320"/>
                    </a:tabLst>
                  </a:pPr>
                  <a:r>
                    <a:rPr b="0" lang="en-US" sz="8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Not measurable</a:t>
                  </a:r>
                  <a:endParaRPr b="0" lang="en-US" sz="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94" name="Rounded Rectangle 148"/>
                <p:cNvSpPr/>
                <p:nvPr/>
              </p:nvSpPr>
              <p:spPr>
                <a:xfrm>
                  <a:off x="5551560" y="8931240"/>
                  <a:ext cx="182520" cy="109080"/>
                </a:xfrm>
                <a:prstGeom prst="roundRect">
                  <a:avLst>
                    <a:gd name="adj" fmla="val 16667"/>
                  </a:avLst>
                </a:prstGeom>
                <a:solidFill>
                  <a:srgbClr val="a6a6a6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54720" rIns="54720" tIns="45000" bIns="45000" anchor="ctr">
                  <a:noAutofit/>
                </a:bodyPr>
                <a:p>
                  <a:pPr algn="ctr">
                    <a:lnSpc>
                      <a:spcPct val="9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</p:grpSp>
        <p:sp>
          <p:nvSpPr>
            <p:cNvPr id="195" name="Straight Connector 144"/>
            <p:cNvSpPr/>
            <p:nvPr/>
          </p:nvSpPr>
          <p:spPr>
            <a:xfrm>
              <a:off x="1008000" y="4530960"/>
              <a:ext cx="48592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6" name="Straight Connector 145"/>
            <p:cNvSpPr/>
            <p:nvPr/>
          </p:nvSpPr>
          <p:spPr>
            <a:xfrm>
              <a:off x="1008000" y="8579160"/>
              <a:ext cx="48592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7" name="Straight Connector 146"/>
            <p:cNvSpPr/>
            <p:nvPr/>
          </p:nvSpPr>
          <p:spPr>
            <a:xfrm>
              <a:off x="1008000" y="8623440"/>
              <a:ext cx="48592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8" name="Straight Connector 147"/>
            <p:cNvSpPr/>
            <p:nvPr/>
          </p:nvSpPr>
          <p:spPr>
            <a:xfrm>
              <a:off x="1019160" y="4229280"/>
              <a:ext cx="48592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9" name="Straight Connector 148"/>
            <p:cNvSpPr/>
            <p:nvPr/>
          </p:nvSpPr>
          <p:spPr>
            <a:xfrm>
              <a:off x="1011240" y="4278600"/>
              <a:ext cx="48592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0" name="Straight Connector 149"/>
            <p:cNvSpPr/>
            <p:nvPr/>
          </p:nvSpPr>
          <p:spPr>
            <a:xfrm>
              <a:off x="1003320" y="147600"/>
              <a:ext cx="48592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1" name="TextBox 26"/>
            <p:cNvSpPr/>
            <p:nvPr/>
          </p:nvSpPr>
          <p:spPr>
            <a:xfrm rot="16200000">
              <a:off x="5231160" y="6507720"/>
              <a:ext cx="10965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5760"/>
                  <a:tab algn="l" pos="911160"/>
                  <a:tab algn="l" pos="1366920"/>
                  <a:tab algn="l" pos="1822320"/>
                  <a:tab algn="l" pos="2278080"/>
                  <a:tab algn="l" pos="2733840"/>
                  <a:tab algn="l" pos="3189240"/>
                  <a:tab algn="l" pos="3645000"/>
                  <a:tab algn="l" pos="4100400"/>
                  <a:tab algn="l" pos="4556160"/>
                  <a:tab algn="l" pos="5011560"/>
                  <a:tab algn="l" pos="5467320"/>
                  <a:tab algn="l" pos="5923080"/>
                  <a:tab algn="l" pos="6378480"/>
                  <a:tab algn="l" pos="6834240"/>
                  <a:tab algn="l" pos="7289640"/>
                  <a:tab algn="l" pos="7745400"/>
                  <a:tab algn="l" pos="8201160"/>
                  <a:tab algn="l" pos="8656560"/>
                  <a:tab algn="l" pos="911232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ACTIVATION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2" name="TextBox 26"/>
            <p:cNvSpPr/>
            <p:nvPr/>
          </p:nvSpPr>
          <p:spPr>
            <a:xfrm rot="16200000">
              <a:off x="5192280" y="2109240"/>
              <a:ext cx="11743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5760"/>
                  <a:tab algn="l" pos="911160"/>
                  <a:tab algn="l" pos="1366920"/>
                  <a:tab algn="l" pos="1822320"/>
                  <a:tab algn="l" pos="2278080"/>
                  <a:tab algn="l" pos="2733840"/>
                  <a:tab algn="l" pos="3189240"/>
                  <a:tab algn="l" pos="3645000"/>
                  <a:tab algn="l" pos="4100400"/>
                  <a:tab algn="l" pos="4556160"/>
                  <a:tab algn="l" pos="5011560"/>
                  <a:tab algn="l" pos="5467320"/>
                  <a:tab algn="l" pos="5923080"/>
                  <a:tab algn="l" pos="6378480"/>
                  <a:tab algn="l" pos="6834240"/>
                  <a:tab algn="l" pos="7289640"/>
                  <a:tab algn="l" pos="7745400"/>
                  <a:tab algn="l" pos="8201160"/>
                  <a:tab algn="l" pos="8656560"/>
                  <a:tab algn="l" pos="911232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EXPRESSION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5929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11-26T17:26:42Z</dcterms:created>
  <dc:creator>Rory Shott</dc:creator>
  <dc:description/>
  <dc:language>en-US</dc:language>
  <cp:lastModifiedBy>Luis Schang</cp:lastModifiedBy>
  <cp:lastPrinted>2014-04-11T19:50:35Z</cp:lastPrinted>
  <dcterms:modified xsi:type="dcterms:W3CDTF">2014-08-12T19:02:34Z</dcterms:modified>
  <cp:revision>906</cp:revision>
  <dc:subject/>
  <dc:title>PowerPoint Presentation</dc:title>
</cp:coreProperties>
</file>